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9"/>
  </p:notesMasterIdLst>
  <p:sldIdLst>
    <p:sldId id="322" r:id="rId2"/>
    <p:sldId id="316" r:id="rId3"/>
    <p:sldId id="317" r:id="rId4"/>
    <p:sldId id="318" r:id="rId5"/>
    <p:sldId id="319" r:id="rId6"/>
    <p:sldId id="320" r:id="rId7"/>
    <p:sldId id="321" r:id="rId8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4148548-7CED-1C40-FBBA-0388C88D973E}" name="Campbell, Michelle (NIH/NIEHS) [E]" initials="CM([" userId="S::campbel5@nih.gov::0c958d22-5302-4170-9394-c492379af139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orley, Brian" initials="CB" lastIdx="3" clrIdx="0">
    <p:extLst>
      <p:ext uri="{19B8F6BF-5375-455C-9EA6-DF929625EA0E}">
        <p15:presenceInfo xmlns:p15="http://schemas.microsoft.com/office/powerpoint/2012/main" userId="S::Chorley.Brian@epa.gov::64fad1c8-89e0-48a4-b886-ce6fd6148df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A7500"/>
    <a:srgbClr val="FE7F00"/>
    <a:srgbClr val="AC8300"/>
    <a:srgbClr val="E0E0E0"/>
    <a:srgbClr val="E4E4E4"/>
    <a:srgbClr val="DEDEDE"/>
    <a:srgbClr val="FFFF99"/>
    <a:srgbClr val="FF9021"/>
    <a:srgbClr val="0000FF"/>
    <a:srgbClr val="66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585" autoAdjust="0"/>
    <p:restoredTop sz="93275" autoAdjust="0"/>
  </p:normalViewPr>
  <p:slideViewPr>
    <p:cSldViewPr snapToGrid="0">
      <p:cViewPr varScale="1">
        <p:scale>
          <a:sx n="66" d="100"/>
          <a:sy n="66" d="100"/>
        </p:scale>
        <p:origin x="2390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0" d="100"/>
        <a:sy n="19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8/10/relationships/authors" Target="authors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1B947A-FC11-499E-8980-D94F6D546AF9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70"/>
            <a:ext cx="3037840" cy="4664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70"/>
            <a:ext cx="3037840" cy="4664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17BA63-4BA0-4E2F-AEE0-2077ECDB88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7572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6F250-4C31-46D1-90F2-F3AE40811690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F9B08-4B45-4BB5-8CA5-5F195CCC1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180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6F250-4C31-46D1-90F2-F3AE40811690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F9B08-4B45-4BB5-8CA5-5F195CCC1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821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6F250-4C31-46D1-90F2-F3AE40811690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F9B08-4B45-4BB5-8CA5-5F195CCC1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54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6F250-4C31-46D1-90F2-F3AE40811690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F9B08-4B45-4BB5-8CA5-5F195CCC1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53373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6F250-4C31-46D1-90F2-F3AE40811690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F9B08-4B45-4BB5-8CA5-5F195CCC1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366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6F250-4C31-46D1-90F2-F3AE40811690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F9B08-4B45-4BB5-8CA5-5F195CCC1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069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6F250-4C31-46D1-90F2-F3AE40811690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F9B08-4B45-4BB5-8CA5-5F195CCC1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030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6F250-4C31-46D1-90F2-F3AE40811690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F9B08-4B45-4BB5-8CA5-5F195CCC1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66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6F250-4C31-46D1-90F2-F3AE40811690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F9B08-4B45-4BB5-8CA5-5F195CCC1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881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6F250-4C31-46D1-90F2-F3AE40811690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F9B08-4B45-4BB5-8CA5-5F195CCC1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0474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6F250-4C31-46D1-90F2-F3AE40811690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F9B08-4B45-4BB5-8CA5-5F195CCC1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628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86F250-4C31-46D1-90F2-F3AE40811690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2F9B08-4B45-4BB5-8CA5-5F195CCC1D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646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7" Type="http://schemas.openxmlformats.org/officeDocument/2006/relationships/image" Target="../media/image11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7.bin"/><Relationship Id="rId5" Type="http://schemas.openxmlformats.org/officeDocument/2006/relationships/image" Target="../media/image10.emf"/><Relationship Id="rId4" Type="http://schemas.openxmlformats.org/officeDocument/2006/relationships/oleObject" Target="../embeddings/oleObject6.bin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20.png"/><Relationship Id="rId4" Type="http://schemas.openxmlformats.org/officeDocument/2006/relationships/image" Target="../media/image17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F7ABFBA-4C3A-3092-956E-8663FE3A1213}"/>
              </a:ext>
            </a:extLst>
          </p:cNvPr>
          <p:cNvSpPr txBox="1"/>
          <p:nvPr/>
        </p:nvSpPr>
        <p:spPr>
          <a:xfrm>
            <a:off x="6116172" y="-8468"/>
            <a:ext cx="7682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776C6CC-093A-91EC-EEC0-3CEC3DD3F0D7}"/>
              </a:ext>
            </a:extLst>
          </p:cNvPr>
          <p:cNvSpPr/>
          <p:nvPr/>
        </p:nvSpPr>
        <p:spPr>
          <a:xfrm>
            <a:off x="107880" y="7561345"/>
            <a:ext cx="6669523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. S1. </a:t>
            </a:r>
            <a:r>
              <a:rPr lang="en-US" sz="1000" b="1" dirty="0">
                <a:effectLst/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Association between neutrophil (granulocyte)-lymphocyte ratio (NLR) and (A) gestational age (GA) or (B) days of neonatal intensive care unit (NICU) oxygen (O</a:t>
            </a:r>
            <a:r>
              <a:rPr lang="en-US" sz="1000" b="1" baseline="-25000" dirty="0">
                <a:effectLst/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2</a:t>
            </a:r>
            <a:r>
              <a:rPr lang="en-US" sz="1000" b="1" dirty="0">
                <a:effectLst/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) supplementation in preterm neonates diagnosed with bronchopulmonary dysplasia (BPD) or without (nonBPD) on postnatal day 28. </a:t>
            </a:r>
            <a:r>
              <a:rPr lang="en-US" sz="1000" dirty="0">
                <a:highlight>
                  <a:srgbClr val="FFFF00"/>
                </a:highlight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Hi</a:t>
            </a:r>
            <a:r>
              <a:rPr lang="en-US" sz="1000" dirty="0">
                <a:effectLst/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gher NLR was associated with prolonged NICU O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2</a:t>
            </a:r>
            <a:r>
              <a:rPr lang="en-US" sz="1000" dirty="0">
                <a:effectLst/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 days and shorter GA. </a:t>
            </a:r>
            <a:r>
              <a:rPr lang="en-US" sz="1000" dirty="0"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n = 82 (71 nonBPD, 11 BPD). </a:t>
            </a:r>
            <a:endParaRPr lang="en-US" sz="1000" dirty="0">
              <a:effectLst/>
              <a:latin typeface="Arial" panose="020B0604020202020204" pitchFamily="34" charset="0"/>
              <a:ea typeface="Batang" panose="02030600000101010101" pitchFamily="18" charset="-127"/>
              <a:cs typeface="Arial" panose="020B0604020202020204" pitchFamily="34" charset="0"/>
            </a:endParaRPr>
          </a:p>
          <a:p>
            <a:pPr algn="just">
              <a:defRPr/>
            </a:pP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84152089-2A1A-C3CE-F118-3778E715595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98217066"/>
              </p:ext>
            </p:extLst>
          </p:nvPr>
        </p:nvGraphicFramePr>
        <p:xfrm>
          <a:off x="1006539" y="3898669"/>
          <a:ext cx="3698875" cy="2697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698170" imgH="2697192" progId="Prism9.Document">
                  <p:embed/>
                </p:oleObj>
              </mc:Choice>
              <mc:Fallback>
                <p:oleObj name="Prism 9" r:id="rId2" imgW="3698170" imgH="269719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06539" y="3898669"/>
                        <a:ext cx="3698875" cy="2697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7B6ECFBA-7A38-30F0-28EA-7922EEAD2C9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2393020"/>
              </p:ext>
            </p:extLst>
          </p:nvPr>
        </p:nvGraphicFramePr>
        <p:xfrm>
          <a:off x="1006539" y="1318472"/>
          <a:ext cx="3698875" cy="2724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698170" imgH="2724549" progId="Prism9.Document">
                  <p:embed/>
                </p:oleObj>
              </mc:Choice>
              <mc:Fallback>
                <p:oleObj name="Prism 9" r:id="rId4" imgW="3698170" imgH="272454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006539" y="1318472"/>
                        <a:ext cx="3698875" cy="2724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7370">
            <a:extLst>
              <a:ext uri="{FF2B5EF4-FFF2-40B4-BE49-F238E27FC236}">
                <a16:creationId xmlns:a16="http://schemas.microsoft.com/office/drawing/2014/main" id="{2B098DEF-9D54-D62A-2EA8-E6218DD14E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164" y="1408716"/>
            <a:ext cx="241890" cy="24273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1pPr>
            <a:lvl2pPr marL="742950" indent="-28575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2pPr>
            <a:lvl3pPr marL="11430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3pPr>
            <a:lvl4pPr marL="16002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4pPr>
            <a:lvl5pPr marL="20574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5pPr>
            <a:lvl6pPr marL="25146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6pPr>
            <a:lvl7pPr marL="29718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7pPr>
            <a:lvl8pPr marL="34290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8pPr>
            <a:lvl9pPr marL="38862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="0" dirty="0">
                <a:solidFill>
                  <a:prstClr val="black"/>
                </a:solidFill>
                <a:ea typeface="굴림" panose="020B0600000101010101" pitchFamily="34" charset="-127"/>
                <a:cs typeface="Arial" panose="020B0604020202020204" pitchFamily="34" charset="0"/>
              </a:rPr>
              <a:t>A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="0" dirty="0">
                <a:solidFill>
                  <a:prstClr val="black"/>
                </a:solidFill>
                <a:ea typeface="굴림" panose="020B0600000101010101" pitchFamily="34" charset="-127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8030698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38D78B0-7BD0-487B-A36A-E21589D88599}"/>
              </a:ext>
            </a:extLst>
          </p:cNvPr>
          <p:cNvSpPr txBox="1"/>
          <p:nvPr/>
        </p:nvSpPr>
        <p:spPr>
          <a:xfrm>
            <a:off x="6116172" y="-8468"/>
            <a:ext cx="7682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en-US" sz="1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en-US" sz="1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65D1CF7B-C352-4BD4-807B-B79C3A647438}"/>
              </a:ext>
            </a:extLst>
          </p:cNvPr>
          <p:cNvGrpSpPr/>
          <p:nvPr/>
        </p:nvGrpSpPr>
        <p:grpSpPr>
          <a:xfrm>
            <a:off x="633969" y="2619309"/>
            <a:ext cx="5482204" cy="3226289"/>
            <a:chOff x="759329" y="1277205"/>
            <a:chExt cx="5482204" cy="322628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F641630F-B605-4925-9369-FD02C9307DF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17392" y="1631867"/>
              <a:ext cx="5124141" cy="2871627"/>
            </a:xfrm>
            <a:prstGeom prst="rect">
              <a:avLst/>
            </a:prstGeom>
          </p:spPr>
        </p:pic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D4B8D13C-B5F7-4748-8F76-4D75EA95C70F}"/>
                </a:ext>
              </a:extLst>
            </p:cNvPr>
            <p:cNvGrpSpPr/>
            <p:nvPr/>
          </p:nvGrpSpPr>
          <p:grpSpPr>
            <a:xfrm>
              <a:off x="759329" y="1277205"/>
              <a:ext cx="5306506" cy="3209577"/>
              <a:chOff x="-314313" y="4261171"/>
              <a:chExt cx="5306506" cy="3209577"/>
            </a:xfrm>
          </p:grpSpPr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D6507D2D-B5A7-46D5-A744-ABE7090528D3}"/>
                  </a:ext>
                </a:extLst>
              </p:cNvPr>
              <p:cNvSpPr txBox="1"/>
              <p:nvPr/>
            </p:nvSpPr>
            <p:spPr>
              <a:xfrm>
                <a:off x="-314313" y="4413321"/>
                <a:ext cx="2480532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PD vs nonBPD in Cord Blood</a:t>
                </a:r>
              </a:p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WAS:RNA-Seq Common 134 Genes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B2786EDF-D0BF-466B-A79E-66F751F5583A}"/>
                  </a:ext>
                </a:extLst>
              </p:cNvPr>
              <p:cNvSpPr txBox="1"/>
              <p:nvPr/>
            </p:nvSpPr>
            <p:spPr>
              <a:xfrm>
                <a:off x="3661995" y="5913780"/>
                <a:ext cx="130407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Arial Narrow" panose="020B0606020202030204" pitchFamily="34" charset="0"/>
                  </a:rPr>
                  <a:t>Immune &amp; Inflammation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86A3AB31-C7B5-49B2-9F72-D4FA50A28CB9}"/>
                  </a:ext>
                </a:extLst>
              </p:cNvPr>
              <p:cNvSpPr txBox="1"/>
              <p:nvPr/>
            </p:nvSpPr>
            <p:spPr>
              <a:xfrm>
                <a:off x="4144369" y="6634204"/>
                <a:ext cx="8478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Arial Narrow" panose="020B0606020202030204" pitchFamily="34" charset="0"/>
                  </a:rPr>
                  <a:t>Development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BFA8AEE3-A533-4415-8FC2-E9F7B9D9220D}"/>
                  </a:ext>
                </a:extLst>
              </p:cNvPr>
              <p:cNvSpPr txBox="1"/>
              <p:nvPr/>
            </p:nvSpPr>
            <p:spPr>
              <a:xfrm>
                <a:off x="4439849" y="7224527"/>
                <a:ext cx="50009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Arial Narrow" panose="020B0606020202030204" pitchFamily="34" charset="0"/>
                  </a:rPr>
                  <a:t>Others</a:t>
                </a:r>
              </a:p>
            </p:txBody>
          </p:sp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40FE5628-766E-46F2-AAE9-E831BF2F81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053008" y="4261171"/>
                <a:ext cx="1105628" cy="645418"/>
              </a:xfrm>
              <a:prstGeom prst="rect">
                <a:avLst/>
              </a:prstGeom>
            </p:spPr>
          </p:pic>
        </p:grpSp>
      </p:grpSp>
      <p:sp>
        <p:nvSpPr>
          <p:cNvPr id="13" name="Rectangle 12">
            <a:extLst>
              <a:ext uri="{FF2B5EF4-FFF2-40B4-BE49-F238E27FC236}">
                <a16:creationId xmlns:a16="http://schemas.microsoft.com/office/drawing/2014/main" id="{0C79C909-975E-4136-8392-E7941A65BFC0}"/>
              </a:ext>
            </a:extLst>
          </p:cNvPr>
          <p:cNvSpPr/>
          <p:nvPr/>
        </p:nvSpPr>
        <p:spPr>
          <a:xfrm>
            <a:off x="83816" y="7561345"/>
            <a:ext cx="6669523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S2. Cord blood genome-wide gene expression analysis of bronchopulmonary dysplasia (BPD) and overlapping genes between epigenome and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ranscriptome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A) A volcano plot depicts  Log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transforme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values against Log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transformed fold changes of differentially expressed genes (DEGs) in BPD relative to nonBPD determined by RNA sequencing analysis in cord blood (adjusted by sex, gestational age, birth weight, and 6 cell type %). FDR = false discovery rate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B) Among 1,685 BPD-associated DEGs (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&lt; 0.05), 134 genes were commonly annotated in BPD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2,164 genes in 1,581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t FDR 1%) determined by epigenome-wide association analysis (EWAS). These common genes may be involved in allergic response, inflammatory cell response, viral infection, developmental defects, and metabolism. Top enriched pathways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 cord blood BPD-EWAS are retrieved from previous publication [22]. 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EE9A8C03-01DA-4E08-88C3-15047B91C6C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5800" y="347686"/>
            <a:ext cx="2245507" cy="2284902"/>
          </a:xfrm>
          <a:prstGeom prst="rect">
            <a:avLst/>
          </a:prstGeom>
        </p:spPr>
      </p:pic>
      <p:sp>
        <p:nvSpPr>
          <p:cNvPr id="18" name="Rectangle 7370">
            <a:extLst>
              <a:ext uri="{FF2B5EF4-FFF2-40B4-BE49-F238E27FC236}">
                <a16:creationId xmlns:a16="http://schemas.microsoft.com/office/drawing/2014/main" id="{6EB5DE9A-A655-4A38-B3B5-2739D6D375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2684" y="358849"/>
            <a:ext cx="241890" cy="24273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1pPr>
            <a:lvl2pPr marL="742950" indent="-28575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2pPr>
            <a:lvl3pPr marL="11430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3pPr>
            <a:lvl4pPr marL="16002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4pPr>
            <a:lvl5pPr marL="20574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5pPr>
            <a:lvl6pPr marL="25146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6pPr>
            <a:lvl7pPr marL="29718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7pPr>
            <a:lvl8pPr marL="34290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8pPr>
            <a:lvl9pPr marL="38862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="0" dirty="0">
                <a:solidFill>
                  <a:prstClr val="black"/>
                </a:solidFill>
                <a:ea typeface="굴림" panose="020B0600000101010101" pitchFamily="34" charset="-127"/>
                <a:cs typeface="Arial" panose="020B0604020202020204" pitchFamily="34" charset="0"/>
              </a:rPr>
              <a:t>A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="0" dirty="0">
                <a:solidFill>
                  <a:prstClr val="black"/>
                </a:solidFill>
                <a:ea typeface="굴림" panose="020B0600000101010101" pitchFamily="34" charset="-127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2578181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38D78B0-7BD0-487B-A36A-E21589D88599}"/>
              </a:ext>
            </a:extLst>
          </p:cNvPr>
          <p:cNvSpPr txBox="1"/>
          <p:nvPr/>
        </p:nvSpPr>
        <p:spPr>
          <a:xfrm>
            <a:off x="6045851" y="9754"/>
            <a:ext cx="8286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  <a:endParaRPr lang="en-US" sz="14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33D8B13C-6A11-4E9D-A8A9-839762E58E0A}"/>
              </a:ext>
            </a:extLst>
          </p:cNvPr>
          <p:cNvSpPr/>
          <p:nvPr/>
        </p:nvSpPr>
        <p:spPr>
          <a:xfrm>
            <a:off x="87942" y="7299983"/>
            <a:ext cx="6654381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S3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pigenome-wide association study (EWAS) and genome-wide gene expression analysis of bronchopulmonary dysplasia (BPD) blood cells on postnatal day 14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A) Numbers of differentially methylate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determined by EWAS and differentially expressed genes determined by RNA-sequencing (RNA-Seq) analysis indicate relatively greater DNA hypomethylation and gene upregulation in bronchopulmonary dysplasia (BPD) blood cells than in nonBPD ones on day 14. (B) A volcano plot depicts Log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transforme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values against Log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transformed fold changes of differentially expressed genes in BPD relative to nonBPD on day 14 (adjusted by sex, gestational age, birth weight, and six cell type %). BF = Bonferroni’s cut-off. FDR = false discovery rate. (C)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tween BPD-associated epigenome (3,801 annotated genes in 2,871 </a:t>
            </a:r>
            <a:r>
              <a:rPr lang="en-U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t FDR 1%) and transcriptome (731 genes at </a:t>
            </a:r>
            <a:r>
              <a:rPr lang="en-US" sz="10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&lt; 0.01), 85 genes are common. These overlapping genes are predicted to play key roles in T cell development and interaction as well as other pathways including cellular assembly, development, DNA degradation and cell death. </a:t>
            </a:r>
          </a:p>
        </p:txBody>
      </p:sp>
      <p:sp>
        <p:nvSpPr>
          <p:cNvPr id="56" name="Rectangle 7370">
            <a:extLst>
              <a:ext uri="{FF2B5EF4-FFF2-40B4-BE49-F238E27FC236}">
                <a16:creationId xmlns:a16="http://schemas.microsoft.com/office/drawing/2014/main" id="{3568BBE7-BDC2-449B-8DBA-B67E605F3A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2684" y="454712"/>
            <a:ext cx="3312996" cy="2506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1pPr>
            <a:lvl2pPr marL="742950" indent="-28575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2pPr>
            <a:lvl3pPr marL="11430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3pPr>
            <a:lvl4pPr marL="16002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4pPr>
            <a:lvl5pPr marL="20574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5pPr>
            <a:lvl6pPr marL="25146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6pPr>
            <a:lvl7pPr marL="29718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7pPr>
            <a:lvl8pPr marL="34290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8pPr>
            <a:lvl9pPr marL="38862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="0" dirty="0">
                <a:solidFill>
                  <a:prstClr val="black"/>
                </a:solidFill>
                <a:ea typeface="굴림" panose="020B0600000101010101" pitchFamily="34" charset="-127"/>
                <a:cs typeface="Arial" panose="020B0604020202020204" pitchFamily="34" charset="0"/>
              </a:rPr>
              <a:t>A                                                                      B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C1B923A0-2434-440A-86F1-6C35161B72FD}"/>
              </a:ext>
            </a:extLst>
          </p:cNvPr>
          <p:cNvSpPr txBox="1"/>
          <p:nvPr/>
        </p:nvSpPr>
        <p:spPr>
          <a:xfrm>
            <a:off x="859290" y="809654"/>
            <a:ext cx="22514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PD vs nonBPD-AnyO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on Day 14</a:t>
            </a:r>
          </a:p>
        </p:txBody>
      </p:sp>
      <p:pic>
        <p:nvPicPr>
          <p:cNvPr id="63" name="Picture 62" descr="A picture containing diagram&#10;&#10;Description automatically generated">
            <a:extLst>
              <a:ext uri="{FF2B5EF4-FFF2-40B4-BE49-F238E27FC236}">
                <a16:creationId xmlns:a16="http://schemas.microsoft.com/office/drawing/2014/main" id="{F35EA34A-2ABE-43D7-9021-7B193C01BC0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80" t="11192" r="15280" b="12900"/>
          <a:stretch/>
        </p:blipFill>
        <p:spPr>
          <a:xfrm>
            <a:off x="2873552" y="3111144"/>
            <a:ext cx="2088416" cy="1491283"/>
          </a:xfrm>
          <a:prstGeom prst="rect">
            <a:avLst/>
          </a:prstGeom>
        </p:spPr>
      </p:pic>
      <p:grpSp>
        <p:nvGrpSpPr>
          <p:cNvPr id="64" name="Group 63">
            <a:extLst>
              <a:ext uri="{FF2B5EF4-FFF2-40B4-BE49-F238E27FC236}">
                <a16:creationId xmlns:a16="http://schemas.microsoft.com/office/drawing/2014/main" id="{D0518EDF-4AF9-4090-8165-7D526512529E}"/>
              </a:ext>
            </a:extLst>
          </p:cNvPr>
          <p:cNvGrpSpPr/>
          <p:nvPr/>
        </p:nvGrpSpPr>
        <p:grpSpPr>
          <a:xfrm>
            <a:off x="1232663" y="3478724"/>
            <a:ext cx="907621" cy="444774"/>
            <a:chOff x="2387230" y="466664"/>
            <a:chExt cx="907621" cy="444774"/>
          </a:xfrm>
        </p:grpSpPr>
        <p:sp>
          <p:nvSpPr>
            <p:cNvPr id="65" name="Oval 64">
              <a:extLst>
                <a:ext uri="{FF2B5EF4-FFF2-40B4-BE49-F238E27FC236}">
                  <a16:creationId xmlns:a16="http://schemas.microsoft.com/office/drawing/2014/main" id="{836C71EF-DF65-4B0B-B180-37225A350584}"/>
                </a:ext>
              </a:extLst>
            </p:cNvPr>
            <p:cNvSpPr/>
            <p:nvPr/>
          </p:nvSpPr>
          <p:spPr>
            <a:xfrm>
              <a:off x="2596946" y="618830"/>
              <a:ext cx="287890" cy="292608"/>
            </a:xfrm>
            <a:prstGeom prst="ellipse">
              <a:avLst/>
            </a:prstGeom>
            <a:ln/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66" name="Oval 65">
              <a:extLst>
                <a:ext uri="{FF2B5EF4-FFF2-40B4-BE49-F238E27FC236}">
                  <a16:creationId xmlns:a16="http://schemas.microsoft.com/office/drawing/2014/main" id="{8087D6DE-BD71-416D-8678-60F363754702}"/>
                </a:ext>
              </a:extLst>
            </p:cNvPr>
            <p:cNvSpPr/>
            <p:nvPr/>
          </p:nvSpPr>
          <p:spPr>
            <a:xfrm>
              <a:off x="2743463" y="618830"/>
              <a:ext cx="287890" cy="292608"/>
            </a:xfrm>
            <a:prstGeom prst="ellipse">
              <a:avLst/>
            </a:prstGeom>
            <a:noFill/>
            <a:ln/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EFD550E6-D2F3-4D9F-BCC6-065C013C7988}"/>
                </a:ext>
              </a:extLst>
            </p:cNvPr>
            <p:cNvSpPr txBox="1"/>
            <p:nvPr/>
          </p:nvSpPr>
          <p:spPr>
            <a:xfrm>
              <a:off x="2662180" y="66459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85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7CBEB0B9-0E0E-4991-A022-7E27A94F2B03}"/>
                </a:ext>
              </a:extLst>
            </p:cNvPr>
            <p:cNvSpPr txBox="1"/>
            <p:nvPr/>
          </p:nvSpPr>
          <p:spPr>
            <a:xfrm>
              <a:off x="2387230" y="466664"/>
              <a:ext cx="9076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 Narrow" panose="020B0606020202030204" pitchFamily="34" charset="0"/>
                </a:rPr>
                <a:t>EWAS     RNA-Seq</a:t>
              </a:r>
            </a:p>
          </p:txBody>
        </p:sp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5D16F425-F689-43AA-80B4-F521E3409472}"/>
              </a:ext>
            </a:extLst>
          </p:cNvPr>
          <p:cNvGrpSpPr/>
          <p:nvPr/>
        </p:nvGrpSpPr>
        <p:grpSpPr>
          <a:xfrm>
            <a:off x="1029434" y="4014074"/>
            <a:ext cx="1345735" cy="461665"/>
            <a:chOff x="5409578" y="6472853"/>
            <a:chExt cx="1345735" cy="461665"/>
          </a:xfrm>
        </p:grpSpPr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789D5126-56DC-435F-A74E-CFD3174A444D}"/>
                </a:ext>
              </a:extLst>
            </p:cNvPr>
            <p:cNvGrpSpPr/>
            <p:nvPr/>
          </p:nvGrpSpPr>
          <p:grpSpPr>
            <a:xfrm>
              <a:off x="5454197" y="6472853"/>
              <a:ext cx="1301116" cy="461665"/>
              <a:chOff x="395516" y="6460481"/>
              <a:chExt cx="1301116" cy="461665"/>
            </a:xfrm>
          </p:grpSpPr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E8D5B1CB-2E2E-4F11-923B-79B694790C79}"/>
                  </a:ext>
                </a:extLst>
              </p:cNvPr>
              <p:cNvSpPr txBox="1"/>
              <p:nvPr/>
            </p:nvSpPr>
            <p:spPr>
              <a:xfrm>
                <a:off x="583827" y="6460481"/>
                <a:ext cx="1112805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i="0" dirty="0">
                    <a:latin typeface="Arial" panose="020B0604020202020204" pitchFamily="34" charset="0"/>
                    <a:cs typeface="Arial" panose="020B0604020202020204" pitchFamily="34" charset="0"/>
                  </a:rPr>
                  <a:t>Predicted activation</a:t>
                </a:r>
              </a:p>
              <a:p>
                <a:r>
                  <a:rPr lang="en-US" sz="800" i="0" dirty="0">
                    <a:latin typeface="Arial" panose="020B0604020202020204" pitchFamily="34" charset="0"/>
                    <a:cs typeface="Arial" panose="020B0604020202020204" pitchFamily="34" charset="0"/>
                  </a:rPr>
                  <a:t>Predicted inhibition</a:t>
                </a:r>
              </a:p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enes lower in BPD</a:t>
                </a:r>
                <a:endParaRPr lang="en-US" sz="8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Oval 73">
                <a:extLst>
                  <a:ext uri="{FF2B5EF4-FFF2-40B4-BE49-F238E27FC236}">
                    <a16:creationId xmlns:a16="http://schemas.microsoft.com/office/drawing/2014/main" id="{47C817C4-448D-4741-8DA7-1F67E2026256}"/>
                  </a:ext>
                </a:extLst>
              </p:cNvPr>
              <p:cNvSpPr/>
              <p:nvPr/>
            </p:nvSpPr>
            <p:spPr>
              <a:xfrm>
                <a:off x="395517" y="6776663"/>
                <a:ext cx="248357" cy="106474"/>
              </a:xfrm>
              <a:prstGeom prst="ellipse">
                <a:avLst/>
              </a:prstGeom>
              <a:solidFill>
                <a:srgbClr val="92D050"/>
              </a:solidFill>
              <a:ln w="12700">
                <a:gradFill flip="none" rotWithShape="1">
                  <a:gsLst>
                    <a:gs pos="0">
                      <a:schemeClr val="accent6">
                        <a:lumMod val="67000"/>
                      </a:schemeClr>
                    </a:gs>
                    <a:gs pos="100000">
                      <a:schemeClr val="accent6">
                        <a:lumMod val="60000"/>
                        <a:lumOff val="40000"/>
                      </a:schemeClr>
                    </a:gs>
                  </a:gsLst>
                  <a:lin ang="0" scaled="1"/>
                  <a:tileRect/>
                </a:gra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Rectangle 74">
                <a:extLst>
                  <a:ext uri="{FF2B5EF4-FFF2-40B4-BE49-F238E27FC236}">
                    <a16:creationId xmlns:a16="http://schemas.microsoft.com/office/drawing/2014/main" id="{CBCB33DE-145D-48B8-9990-32D0CBAA6048}"/>
                  </a:ext>
                </a:extLst>
              </p:cNvPr>
              <p:cNvSpPr/>
              <p:nvPr/>
            </p:nvSpPr>
            <p:spPr>
              <a:xfrm>
                <a:off x="395516" y="6651079"/>
                <a:ext cx="248358" cy="106474"/>
              </a:xfrm>
              <a:prstGeom prst="rect">
                <a:avLst/>
              </a:prstGeom>
              <a:solidFill>
                <a:srgbClr val="0070C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A4501AF4-C14F-4D20-A380-E5EE13E0F860}"/>
                </a:ext>
              </a:extLst>
            </p:cNvPr>
            <p:cNvSpPr/>
            <p:nvPr/>
          </p:nvSpPr>
          <p:spPr>
            <a:xfrm>
              <a:off x="5409578" y="6493016"/>
              <a:ext cx="1345735" cy="441502"/>
            </a:xfrm>
            <a:prstGeom prst="rect">
              <a:avLst/>
            </a:prstGeom>
            <a:noFill/>
            <a:ln w="952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C35BF76A-A52F-4870-B708-F232996CC4D5}"/>
                </a:ext>
              </a:extLst>
            </p:cNvPr>
            <p:cNvSpPr/>
            <p:nvPr/>
          </p:nvSpPr>
          <p:spPr>
            <a:xfrm>
              <a:off x="5454197" y="6523780"/>
              <a:ext cx="248356" cy="107690"/>
            </a:xfrm>
            <a:prstGeom prst="rect">
              <a:avLst/>
            </a:prstGeom>
            <a:solidFill>
              <a:srgbClr val="FF66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6" name="TextBox 75">
            <a:extLst>
              <a:ext uri="{FF2B5EF4-FFF2-40B4-BE49-F238E27FC236}">
                <a16:creationId xmlns:a16="http://schemas.microsoft.com/office/drawing/2014/main" id="{5A30D405-2B72-4FA8-9035-41E0A155F258}"/>
              </a:ext>
            </a:extLst>
          </p:cNvPr>
          <p:cNvSpPr txBox="1"/>
          <p:nvPr/>
        </p:nvSpPr>
        <p:spPr>
          <a:xfrm>
            <a:off x="562089" y="3060501"/>
            <a:ext cx="25226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PD vs nonBPD-AnyO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on Day 14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WAS:RNA-Seq Common 85 Genes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9A096831-06EB-4A2D-9EAF-BC9FCA8FF88B}"/>
              </a:ext>
            </a:extLst>
          </p:cNvPr>
          <p:cNvGrpSpPr/>
          <p:nvPr/>
        </p:nvGrpSpPr>
        <p:grpSpPr>
          <a:xfrm>
            <a:off x="2675897" y="1361286"/>
            <a:ext cx="862640" cy="338554"/>
            <a:chOff x="2114209" y="311983"/>
            <a:chExt cx="862640" cy="338554"/>
          </a:xfrm>
        </p:grpSpPr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75E2AD51-F6EE-4455-BFB7-1C5D7A2C4F98}"/>
                </a:ext>
              </a:extLst>
            </p:cNvPr>
            <p:cNvSpPr/>
            <p:nvPr/>
          </p:nvSpPr>
          <p:spPr>
            <a:xfrm>
              <a:off x="2114209" y="388103"/>
              <a:ext cx="141141" cy="57832"/>
            </a:xfrm>
            <a:prstGeom prst="rect">
              <a:avLst/>
            </a:prstGeom>
            <a:solidFill>
              <a:srgbClr val="6666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622FC032-0B41-409E-A98B-83E8D2580DF7}"/>
                </a:ext>
              </a:extLst>
            </p:cNvPr>
            <p:cNvSpPr/>
            <p:nvPr/>
          </p:nvSpPr>
          <p:spPr>
            <a:xfrm>
              <a:off x="2114209" y="504778"/>
              <a:ext cx="141141" cy="57832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F32C7A66-BBA5-4823-8A91-2E49F8DCE01D}"/>
                </a:ext>
              </a:extLst>
            </p:cNvPr>
            <p:cNvSpPr/>
            <p:nvPr/>
          </p:nvSpPr>
          <p:spPr>
            <a:xfrm>
              <a:off x="2284775" y="388103"/>
              <a:ext cx="141141" cy="57832"/>
            </a:xfrm>
            <a:prstGeom prst="rect">
              <a:avLst/>
            </a:prstGeom>
            <a:solidFill>
              <a:srgbClr val="FF902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134020E1-FB1A-4702-A4FB-7C70417D2EDF}"/>
                </a:ext>
              </a:extLst>
            </p:cNvPr>
            <p:cNvSpPr/>
            <p:nvPr/>
          </p:nvSpPr>
          <p:spPr>
            <a:xfrm>
              <a:off x="2284775" y="504778"/>
              <a:ext cx="141141" cy="57832"/>
            </a:xfrm>
            <a:prstGeom prst="rect">
              <a:avLst/>
            </a:prstGeom>
            <a:solidFill>
              <a:srgbClr val="FF66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A61EDE8-0C35-4CD3-BE7F-7236985B4E48}"/>
                </a:ext>
              </a:extLst>
            </p:cNvPr>
            <p:cNvSpPr txBox="1"/>
            <p:nvPr/>
          </p:nvSpPr>
          <p:spPr>
            <a:xfrm>
              <a:off x="2382766" y="311983"/>
              <a:ext cx="5940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DR 1%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F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41E0B345-0E29-4011-9F65-BABBFFB1DCA4}"/>
              </a:ext>
            </a:extLst>
          </p:cNvPr>
          <p:cNvGrpSpPr/>
          <p:nvPr/>
        </p:nvGrpSpPr>
        <p:grpSpPr>
          <a:xfrm>
            <a:off x="2684606" y="1788932"/>
            <a:ext cx="773194" cy="338554"/>
            <a:chOff x="2128561" y="639035"/>
            <a:chExt cx="773194" cy="338554"/>
          </a:xfrm>
        </p:grpSpPr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C7630A24-0570-426D-8F84-467257DF8D1B}"/>
                </a:ext>
              </a:extLst>
            </p:cNvPr>
            <p:cNvSpPr/>
            <p:nvPr/>
          </p:nvSpPr>
          <p:spPr>
            <a:xfrm>
              <a:off x="2128561" y="715155"/>
              <a:ext cx="141141" cy="57832"/>
            </a:xfrm>
            <a:prstGeom prst="rect">
              <a:avLst/>
            </a:prstGeom>
            <a:solidFill>
              <a:srgbClr val="6666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8F89F9EA-51AF-4A9C-B1EA-6D648FAEF3CC}"/>
                </a:ext>
              </a:extLst>
            </p:cNvPr>
            <p:cNvSpPr/>
            <p:nvPr/>
          </p:nvSpPr>
          <p:spPr>
            <a:xfrm>
              <a:off x="2128561" y="831830"/>
              <a:ext cx="141141" cy="57832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1C7CF7A3-5788-45C8-9B4D-5E831A5A24CE}"/>
                </a:ext>
              </a:extLst>
            </p:cNvPr>
            <p:cNvSpPr/>
            <p:nvPr/>
          </p:nvSpPr>
          <p:spPr>
            <a:xfrm>
              <a:off x="2299127" y="715155"/>
              <a:ext cx="141141" cy="57832"/>
            </a:xfrm>
            <a:prstGeom prst="rect">
              <a:avLst/>
            </a:prstGeom>
            <a:solidFill>
              <a:srgbClr val="FF902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010A2333-B099-4CEF-9E09-98F717A75CD2}"/>
                </a:ext>
              </a:extLst>
            </p:cNvPr>
            <p:cNvSpPr/>
            <p:nvPr/>
          </p:nvSpPr>
          <p:spPr>
            <a:xfrm>
              <a:off x="2299127" y="831830"/>
              <a:ext cx="141141" cy="57832"/>
            </a:xfrm>
            <a:prstGeom prst="rect">
              <a:avLst/>
            </a:prstGeom>
            <a:solidFill>
              <a:srgbClr val="FF66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A63C2F2-D2A1-49B2-B0DA-7761A4455392}"/>
                </a:ext>
              </a:extLst>
            </p:cNvPr>
            <p:cNvSpPr txBox="1"/>
            <p:nvPr/>
          </p:nvSpPr>
          <p:spPr>
            <a:xfrm>
              <a:off x="2397118" y="639035"/>
              <a:ext cx="50463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&lt;0.05</a:t>
              </a:r>
            </a:p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&lt;0.01</a:t>
              </a:r>
            </a:p>
          </p:txBody>
        </p:sp>
      </p:grpSp>
      <p:sp>
        <p:nvSpPr>
          <p:cNvPr id="41" name="Rectangle 7370">
            <a:extLst>
              <a:ext uri="{FF2B5EF4-FFF2-40B4-BE49-F238E27FC236}">
                <a16:creationId xmlns:a16="http://schemas.microsoft.com/office/drawing/2014/main" id="{D1A56AC8-B202-4316-A229-D898EA4BA0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2684" y="2959012"/>
            <a:ext cx="304461" cy="3058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1pPr>
            <a:lvl2pPr marL="742950" indent="-28575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2pPr>
            <a:lvl3pPr marL="11430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3pPr>
            <a:lvl4pPr marL="16002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4pPr>
            <a:lvl5pPr marL="20574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5pPr>
            <a:lvl6pPr marL="25146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6pPr>
            <a:lvl7pPr marL="29718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7pPr>
            <a:lvl8pPr marL="34290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8pPr>
            <a:lvl9pPr marL="38862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="0" dirty="0">
                <a:solidFill>
                  <a:prstClr val="black"/>
                </a:solidFill>
                <a:ea typeface="굴림" panose="020B0600000101010101" pitchFamily="34" charset="-127"/>
                <a:cs typeface="Arial" panose="020B0604020202020204" pitchFamily="34" charset="0"/>
              </a:rPr>
              <a:t>C</a:t>
            </a: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굴림" panose="020B0600000101010101" pitchFamily="34" charset="-127"/>
              <a:cs typeface="Arial" panose="020B0604020202020204" pitchFamily="34" charset="0"/>
            </a:endParaRP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525C053E-F870-4788-BAA5-B6EC2AFA871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4849367"/>
              </p:ext>
            </p:extLst>
          </p:nvPr>
        </p:nvGraphicFramePr>
        <p:xfrm>
          <a:off x="513697" y="1088904"/>
          <a:ext cx="2413303" cy="14393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4413823" imgH="2631646" progId="Prism9.Document">
                  <p:embed/>
                </p:oleObj>
              </mc:Choice>
              <mc:Fallback>
                <p:oleObj name="Prism 9" r:id="rId3" imgW="4413823" imgH="263164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13697" y="1088904"/>
                        <a:ext cx="2413303" cy="14393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78370448-14ED-4A0B-BB1C-ED135E08A6D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40266716"/>
              </p:ext>
            </p:extLst>
          </p:nvPr>
        </p:nvGraphicFramePr>
        <p:xfrm>
          <a:off x="3595455" y="424905"/>
          <a:ext cx="2403255" cy="25498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3721642" imgH="3948729" progId="Prism9.Document">
                  <p:embed/>
                </p:oleObj>
              </mc:Choice>
              <mc:Fallback>
                <p:oleObj name="Prism 9" r:id="rId5" imgW="3721642" imgH="394872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95455" y="424905"/>
                        <a:ext cx="2403255" cy="25498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019734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38D78B0-7BD0-487B-A36A-E21589D88599}"/>
              </a:ext>
            </a:extLst>
          </p:cNvPr>
          <p:cNvSpPr txBox="1"/>
          <p:nvPr/>
        </p:nvSpPr>
        <p:spPr>
          <a:xfrm>
            <a:off x="6120946" y="11142"/>
            <a:ext cx="8663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. S4</a:t>
            </a:r>
            <a:endParaRPr lang="en-US" sz="14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0DA57B17-81F8-4A63-851F-D8614BDC52BB}"/>
              </a:ext>
            </a:extLst>
          </p:cNvPr>
          <p:cNvSpPr/>
          <p:nvPr/>
        </p:nvSpPr>
        <p:spPr>
          <a:xfrm>
            <a:off x="141837" y="7362492"/>
            <a:ext cx="6545402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S4. Epigenome-wide association study (EWAS) and genome-wide expression analysis of bronchopulmonary dysplasia (BPD) blood cells on postnatal day 28.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 Numbers of differentially methylated CpGs determined by EWAS and differentially expressed genes determined by RNA-sequencing (RNA-Seq) analysis indicate relatively greater DNA hypomethylation and gene upregulation in BPD than in nonBPD on day 28. (B) A volcano plot depicts Log</a:t>
            </a:r>
            <a:r>
              <a:rPr lang="en-US" sz="1000" baseline="-2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transformed </a:t>
            </a:r>
            <a:r>
              <a:rPr lang="en-US" sz="10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values against Log</a:t>
            </a:r>
            <a:r>
              <a:rPr lang="en-US" sz="1000" baseline="-2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transformed fold changes of differentially expressed genes in BPD relative to nonBPD on day 28 (adjusted by sex, gestational age, birth weight, and six cell type %). BF = Bonferroni’s cut-off. FDR = false discovery rate. (C) Between BPD-associated epigenome (3,173 annotated genes in 2,299 CpGs at FDR 1%) and transcriptome (312 genes at </a:t>
            </a:r>
            <a:r>
              <a:rPr lang="en-US" sz="10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&lt; 0.05), 30 genes are found to be common. These overlapping genes may play key roles in lipid metabolism, microbial infection, cardiovascular disorders, cell death and development, and cell cycle.</a:t>
            </a:r>
          </a:p>
        </p:txBody>
      </p:sp>
      <p:sp>
        <p:nvSpPr>
          <p:cNvPr id="37" name="Rectangle 7370">
            <a:extLst>
              <a:ext uri="{FF2B5EF4-FFF2-40B4-BE49-F238E27FC236}">
                <a16:creationId xmlns:a16="http://schemas.microsoft.com/office/drawing/2014/main" id="{0FF16B75-6C67-4A69-B516-F36403A947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5440" y="423842"/>
            <a:ext cx="304461" cy="24363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1pPr>
            <a:lvl2pPr marL="742950" indent="-28575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2pPr>
            <a:lvl3pPr marL="11430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3pPr>
            <a:lvl4pPr marL="16002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4pPr>
            <a:lvl5pPr marL="20574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5pPr>
            <a:lvl6pPr marL="25146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6pPr>
            <a:lvl7pPr marL="29718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7pPr>
            <a:lvl8pPr marL="34290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8pPr>
            <a:lvl9pPr marL="38862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="0" dirty="0">
                <a:solidFill>
                  <a:prstClr val="black"/>
                </a:solidFill>
                <a:ea typeface="굴림" panose="020B0600000101010101" pitchFamily="34" charset="-127"/>
                <a:cs typeface="Arial" panose="020B0604020202020204" pitchFamily="34" charset="0"/>
              </a:rPr>
              <a:t>A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noProof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굴림" panose="020B0600000101010101" pitchFamily="34" charset="-127"/>
                <a:cs typeface="Arial" panose="020B0604020202020204" pitchFamily="34" charset="0"/>
              </a:rPr>
              <a:t>C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굴림" panose="020B0600000101010101" pitchFamily="34" charset="-127"/>
              <a:cs typeface="Arial" panose="020B0604020202020204" pitchFamily="34" charset="0"/>
            </a:endParaRP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C4A77ED8-B403-4F75-AF20-7F60E6CBC749}"/>
              </a:ext>
            </a:extLst>
          </p:cNvPr>
          <p:cNvGrpSpPr/>
          <p:nvPr/>
        </p:nvGrpSpPr>
        <p:grpSpPr>
          <a:xfrm>
            <a:off x="2991138" y="3067808"/>
            <a:ext cx="907621" cy="444774"/>
            <a:chOff x="2387230" y="466664"/>
            <a:chExt cx="907621" cy="444774"/>
          </a:xfrm>
        </p:grpSpPr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4A756951-F384-4FC1-9D8A-E3C652B074C8}"/>
                </a:ext>
              </a:extLst>
            </p:cNvPr>
            <p:cNvSpPr/>
            <p:nvPr/>
          </p:nvSpPr>
          <p:spPr>
            <a:xfrm>
              <a:off x="2596946" y="618830"/>
              <a:ext cx="287890" cy="292608"/>
            </a:xfrm>
            <a:prstGeom prst="ellipse">
              <a:avLst/>
            </a:prstGeom>
            <a:ln/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14" name="Oval 13">
              <a:extLst>
                <a:ext uri="{FF2B5EF4-FFF2-40B4-BE49-F238E27FC236}">
                  <a16:creationId xmlns:a16="http://schemas.microsoft.com/office/drawing/2014/main" id="{D3747FE8-E00E-48EF-A9F8-9DEA56DAE34F}"/>
                </a:ext>
              </a:extLst>
            </p:cNvPr>
            <p:cNvSpPr/>
            <p:nvPr/>
          </p:nvSpPr>
          <p:spPr>
            <a:xfrm>
              <a:off x="2743463" y="618830"/>
              <a:ext cx="287890" cy="292608"/>
            </a:xfrm>
            <a:prstGeom prst="ellipse">
              <a:avLst/>
            </a:prstGeom>
            <a:noFill/>
            <a:ln/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5686927-98B5-4380-B5EE-5FBBB0359F76}"/>
                </a:ext>
              </a:extLst>
            </p:cNvPr>
            <p:cNvSpPr txBox="1"/>
            <p:nvPr/>
          </p:nvSpPr>
          <p:spPr>
            <a:xfrm>
              <a:off x="2662180" y="66459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B13DE51-958A-4325-8B69-363D3BF97C5D}"/>
                </a:ext>
              </a:extLst>
            </p:cNvPr>
            <p:cNvSpPr txBox="1"/>
            <p:nvPr/>
          </p:nvSpPr>
          <p:spPr>
            <a:xfrm>
              <a:off x="2387230" y="466664"/>
              <a:ext cx="9076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 Narrow" panose="020B0606020202030204" pitchFamily="34" charset="0"/>
                </a:rPr>
                <a:t>EWAS     RNA-Seq</a:t>
              </a:r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EE517EBB-6D7F-4773-A37D-A3D7050EDE22}"/>
              </a:ext>
            </a:extLst>
          </p:cNvPr>
          <p:cNvSpPr txBox="1"/>
          <p:nvPr/>
        </p:nvSpPr>
        <p:spPr>
          <a:xfrm>
            <a:off x="528953" y="3109983"/>
            <a:ext cx="25531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PD vs nonBPD-AnyO</a:t>
            </a:r>
            <a:r>
              <a:rPr lang="en-US" sz="1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on Day 28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WAS:RNA-Seq Common 30 Genes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D1F0F5A7-9AC9-4FCF-B266-18C3383B575F}"/>
              </a:ext>
            </a:extLst>
          </p:cNvPr>
          <p:cNvGrpSpPr/>
          <p:nvPr/>
        </p:nvGrpSpPr>
        <p:grpSpPr>
          <a:xfrm>
            <a:off x="820904" y="3189318"/>
            <a:ext cx="4807337" cy="3102312"/>
            <a:chOff x="1066695" y="3098288"/>
            <a:chExt cx="4807337" cy="3102312"/>
          </a:xfrm>
        </p:grpSpPr>
        <p:graphicFrame>
          <p:nvGraphicFramePr>
            <p:cNvPr id="42" name="Object 41">
              <a:extLst>
                <a:ext uri="{FF2B5EF4-FFF2-40B4-BE49-F238E27FC236}">
                  <a16:creationId xmlns:a16="http://schemas.microsoft.com/office/drawing/2014/main" id="{1782926E-666E-4AE9-BB4D-68AB8BA276F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56343106"/>
                </p:ext>
              </p:extLst>
            </p:nvPr>
          </p:nvGraphicFramePr>
          <p:xfrm>
            <a:off x="1066695" y="3098288"/>
            <a:ext cx="4807337" cy="31023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" imgW="6423020" imgH="4145373" progId="Prism9.Document">
                    <p:embed/>
                  </p:oleObj>
                </mc:Choice>
                <mc:Fallback>
                  <p:oleObj name="Prism 9" r:id="rId2" imgW="6423020" imgH="4145373" progId="Prism9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D69901A8-56C0-427E-A352-D157254869D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066695" y="3098288"/>
                          <a:ext cx="4807337" cy="31023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9A03E163-4017-4466-AFF0-20BB32DC5DBC}"/>
                </a:ext>
              </a:extLst>
            </p:cNvPr>
            <p:cNvSpPr txBox="1"/>
            <p:nvPr/>
          </p:nvSpPr>
          <p:spPr>
            <a:xfrm rot="16200000">
              <a:off x="5342216" y="3935707"/>
              <a:ext cx="735309" cy="2976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800"/>
                </a:lnSpc>
              </a:pPr>
              <a:r>
                <a:rPr lang="en-US" sz="900" i="1" dirty="0">
                  <a:latin typeface="Arial Narrow" panose="020B0606020202030204" pitchFamily="34" charset="0"/>
                </a:rPr>
                <a:t>Lipid</a:t>
              </a:r>
            </a:p>
            <a:p>
              <a:pPr algn="ctr">
                <a:lnSpc>
                  <a:spcPts val="800"/>
                </a:lnSpc>
              </a:pPr>
              <a:r>
                <a:rPr lang="en-US" sz="900" i="1" dirty="0">
                  <a:latin typeface="Arial Narrow" panose="020B0606020202030204" pitchFamily="34" charset="0"/>
                </a:rPr>
                <a:t>Metabolism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F0F2B019-26B7-4BEE-A170-503CC56B144B}"/>
                </a:ext>
              </a:extLst>
            </p:cNvPr>
            <p:cNvSpPr txBox="1"/>
            <p:nvPr/>
          </p:nvSpPr>
          <p:spPr>
            <a:xfrm rot="16200000">
              <a:off x="5343968" y="4502718"/>
              <a:ext cx="593304" cy="1950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800"/>
                </a:lnSpc>
              </a:pPr>
              <a:r>
                <a:rPr lang="en-US" sz="900" i="1" dirty="0">
                  <a:latin typeface="Arial Narrow" panose="020B0606020202030204" pitchFamily="34" charset="0"/>
                </a:rPr>
                <a:t>Infection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F544908-1DB9-473B-AF59-B9F2ED70F704}"/>
                </a:ext>
              </a:extLst>
            </p:cNvPr>
            <p:cNvSpPr txBox="1"/>
            <p:nvPr/>
          </p:nvSpPr>
          <p:spPr>
            <a:xfrm rot="16200000">
              <a:off x="5413217" y="4965015"/>
              <a:ext cx="593306" cy="2976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800"/>
                </a:lnSpc>
              </a:pPr>
              <a:r>
                <a:rPr lang="en-US" sz="900" i="1" dirty="0">
                  <a:latin typeface="Arial Narrow" panose="020B0606020202030204" pitchFamily="34" charset="0"/>
                </a:rPr>
                <a:t>Cardio-</a:t>
              </a:r>
            </a:p>
            <a:p>
              <a:pPr algn="ctr">
                <a:lnSpc>
                  <a:spcPts val="800"/>
                </a:lnSpc>
              </a:pPr>
              <a:r>
                <a:rPr lang="en-US" sz="900" i="1" dirty="0">
                  <a:latin typeface="Arial Narrow" panose="020B0606020202030204" pitchFamily="34" charset="0"/>
                </a:rPr>
                <a:t>vascular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DF52A6AF-524C-4A1F-9764-F4FF5FC539B1}"/>
                </a:ext>
              </a:extLst>
            </p:cNvPr>
            <p:cNvSpPr txBox="1"/>
            <p:nvPr/>
          </p:nvSpPr>
          <p:spPr>
            <a:xfrm rot="16200000">
              <a:off x="5372589" y="5470615"/>
              <a:ext cx="674564" cy="2976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800"/>
                </a:lnSpc>
              </a:pPr>
              <a:r>
                <a:rPr lang="en-US" sz="900" i="1" dirty="0">
                  <a:latin typeface="Arial Narrow" panose="020B0606020202030204" pitchFamily="34" charset="0"/>
                </a:rPr>
                <a:t>Cell Death</a:t>
              </a:r>
            </a:p>
            <a:p>
              <a:pPr algn="ctr">
                <a:lnSpc>
                  <a:spcPts val="800"/>
                </a:lnSpc>
              </a:pPr>
              <a:r>
                <a:rPr lang="en-US" sz="900" i="1" dirty="0">
                  <a:latin typeface="Arial Narrow" panose="020B0606020202030204" pitchFamily="34" charset="0"/>
                </a:rPr>
                <a:t>&amp; Growth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F51C2428-DC0A-4938-8403-BC96C4B72A93}"/>
                </a:ext>
              </a:extLst>
            </p:cNvPr>
            <p:cNvSpPr txBox="1"/>
            <p:nvPr/>
          </p:nvSpPr>
          <p:spPr>
            <a:xfrm rot="16200000">
              <a:off x="5446677" y="5872492"/>
              <a:ext cx="422722" cy="1950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800"/>
                </a:lnSpc>
              </a:pPr>
              <a:r>
                <a:rPr lang="en-US" sz="900" i="1" dirty="0">
                  <a:latin typeface="Arial Narrow" panose="020B0606020202030204" pitchFamily="34" charset="0"/>
                </a:rPr>
                <a:t>DNA</a:t>
              </a:r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A9BDC8BD-CAFD-4BDF-889D-89C8945D0CB8}"/>
              </a:ext>
            </a:extLst>
          </p:cNvPr>
          <p:cNvSpPr txBox="1"/>
          <p:nvPr/>
        </p:nvSpPr>
        <p:spPr>
          <a:xfrm>
            <a:off x="1072211" y="665028"/>
            <a:ext cx="23652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PD vs nonBPD-AnyO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on Day 28</a:t>
            </a:r>
          </a:p>
        </p:txBody>
      </p:sp>
      <p:sp>
        <p:nvSpPr>
          <p:cNvPr id="34" name="Rectangle 7370">
            <a:extLst>
              <a:ext uri="{FF2B5EF4-FFF2-40B4-BE49-F238E27FC236}">
                <a16:creationId xmlns:a16="http://schemas.microsoft.com/office/drawing/2014/main" id="{B11A4F21-F214-4D17-A628-5174557DCD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22585" y="361447"/>
            <a:ext cx="304461" cy="2462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1pPr>
            <a:lvl2pPr marL="742950" indent="-28575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2pPr>
            <a:lvl3pPr marL="11430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3pPr>
            <a:lvl4pPr marL="16002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4pPr>
            <a:lvl5pPr marL="20574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5pPr>
            <a:lvl6pPr marL="25146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6pPr>
            <a:lvl7pPr marL="29718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7pPr>
            <a:lvl8pPr marL="34290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8pPr>
            <a:lvl9pPr marL="38862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="0" dirty="0">
                <a:solidFill>
                  <a:prstClr val="black"/>
                </a:solidFill>
                <a:ea typeface="굴림" panose="020B0600000101010101" pitchFamily="34" charset="-127"/>
                <a:cs typeface="Arial" panose="020B0604020202020204" pitchFamily="34" charset="0"/>
              </a:rPr>
              <a:t>B</a:t>
            </a: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굴림" panose="020B0600000101010101" pitchFamily="34" charset="-127"/>
              <a:cs typeface="Arial" panose="020B0604020202020204" pitchFamily="34" charset="0"/>
            </a:endParaRPr>
          </a:p>
        </p:txBody>
      </p:sp>
      <p:grpSp>
        <p:nvGrpSpPr>
          <p:cNvPr id="38" name="Group 37">
            <a:extLst>
              <a:ext uri="{FF2B5EF4-FFF2-40B4-BE49-F238E27FC236}">
                <a16:creationId xmlns:a16="http://schemas.microsoft.com/office/drawing/2014/main" id="{028A98C0-A1EB-4729-8A7A-23224A3FF95B}"/>
              </a:ext>
            </a:extLst>
          </p:cNvPr>
          <p:cNvGrpSpPr/>
          <p:nvPr/>
        </p:nvGrpSpPr>
        <p:grpSpPr>
          <a:xfrm>
            <a:off x="2799932" y="1161067"/>
            <a:ext cx="862640" cy="338554"/>
            <a:chOff x="2114209" y="311983"/>
            <a:chExt cx="862640" cy="338554"/>
          </a:xfrm>
        </p:grpSpPr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EBDC2386-F39E-4D82-A090-75C62BEB3AB9}"/>
                </a:ext>
              </a:extLst>
            </p:cNvPr>
            <p:cNvSpPr/>
            <p:nvPr/>
          </p:nvSpPr>
          <p:spPr>
            <a:xfrm>
              <a:off x="2114209" y="388103"/>
              <a:ext cx="141141" cy="57832"/>
            </a:xfrm>
            <a:prstGeom prst="rect">
              <a:avLst/>
            </a:prstGeom>
            <a:solidFill>
              <a:srgbClr val="6666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53086D97-C984-476B-8B94-928B638C4686}"/>
                </a:ext>
              </a:extLst>
            </p:cNvPr>
            <p:cNvSpPr/>
            <p:nvPr/>
          </p:nvSpPr>
          <p:spPr>
            <a:xfrm>
              <a:off x="2114209" y="504778"/>
              <a:ext cx="141141" cy="57832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5ADDA8F2-7940-45B9-9F96-70513FC6849C}"/>
                </a:ext>
              </a:extLst>
            </p:cNvPr>
            <p:cNvSpPr/>
            <p:nvPr/>
          </p:nvSpPr>
          <p:spPr>
            <a:xfrm>
              <a:off x="2284775" y="388103"/>
              <a:ext cx="141141" cy="57832"/>
            </a:xfrm>
            <a:prstGeom prst="rect">
              <a:avLst/>
            </a:prstGeom>
            <a:solidFill>
              <a:srgbClr val="FF902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088EF7AA-B1CD-4D3B-8965-4EBCB963E36F}"/>
                </a:ext>
              </a:extLst>
            </p:cNvPr>
            <p:cNvSpPr/>
            <p:nvPr/>
          </p:nvSpPr>
          <p:spPr>
            <a:xfrm>
              <a:off x="2284775" y="504778"/>
              <a:ext cx="141141" cy="57832"/>
            </a:xfrm>
            <a:prstGeom prst="rect">
              <a:avLst/>
            </a:prstGeom>
            <a:solidFill>
              <a:srgbClr val="FF66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9977C97E-9EB3-4258-9C50-728884F14593}"/>
                </a:ext>
              </a:extLst>
            </p:cNvPr>
            <p:cNvSpPr txBox="1"/>
            <p:nvPr/>
          </p:nvSpPr>
          <p:spPr>
            <a:xfrm>
              <a:off x="2382766" y="311983"/>
              <a:ext cx="5940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DR 1%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F</a:t>
              </a:r>
            </a:p>
          </p:txBody>
        </p:sp>
      </p:grpSp>
      <p:grpSp>
        <p:nvGrpSpPr>
          <p:cNvPr id="63" name="Group 62">
            <a:extLst>
              <a:ext uri="{FF2B5EF4-FFF2-40B4-BE49-F238E27FC236}">
                <a16:creationId xmlns:a16="http://schemas.microsoft.com/office/drawing/2014/main" id="{0BD6C243-D630-4946-A9C1-41344CFCCA4D}"/>
              </a:ext>
            </a:extLst>
          </p:cNvPr>
          <p:cNvGrpSpPr/>
          <p:nvPr/>
        </p:nvGrpSpPr>
        <p:grpSpPr>
          <a:xfrm>
            <a:off x="2808641" y="1588713"/>
            <a:ext cx="773194" cy="338554"/>
            <a:chOff x="2128561" y="639035"/>
            <a:chExt cx="773194" cy="338554"/>
          </a:xfrm>
        </p:grpSpPr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2033CC84-44CE-4FC5-9C41-EE8FF92EB790}"/>
                </a:ext>
              </a:extLst>
            </p:cNvPr>
            <p:cNvSpPr/>
            <p:nvPr/>
          </p:nvSpPr>
          <p:spPr>
            <a:xfrm>
              <a:off x="2128561" y="715155"/>
              <a:ext cx="141141" cy="57832"/>
            </a:xfrm>
            <a:prstGeom prst="rect">
              <a:avLst/>
            </a:prstGeom>
            <a:solidFill>
              <a:srgbClr val="6666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0F9D2934-76BD-45CE-93B1-DA3B1B44A431}"/>
                </a:ext>
              </a:extLst>
            </p:cNvPr>
            <p:cNvSpPr/>
            <p:nvPr/>
          </p:nvSpPr>
          <p:spPr>
            <a:xfrm>
              <a:off x="2128561" y="831830"/>
              <a:ext cx="141141" cy="57832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F934CE73-F0ED-4C7D-BEFA-A1CA6CF1A2C2}"/>
                </a:ext>
              </a:extLst>
            </p:cNvPr>
            <p:cNvSpPr/>
            <p:nvPr/>
          </p:nvSpPr>
          <p:spPr>
            <a:xfrm>
              <a:off x="2299127" y="715155"/>
              <a:ext cx="141141" cy="57832"/>
            </a:xfrm>
            <a:prstGeom prst="rect">
              <a:avLst/>
            </a:prstGeom>
            <a:solidFill>
              <a:srgbClr val="FF902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13E50D98-C652-4FE3-9206-83A08D60BF34}"/>
                </a:ext>
              </a:extLst>
            </p:cNvPr>
            <p:cNvSpPr/>
            <p:nvPr/>
          </p:nvSpPr>
          <p:spPr>
            <a:xfrm>
              <a:off x="2299127" y="831830"/>
              <a:ext cx="141141" cy="57832"/>
            </a:xfrm>
            <a:prstGeom prst="rect">
              <a:avLst/>
            </a:prstGeom>
            <a:solidFill>
              <a:srgbClr val="FF66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80537FD2-89E1-4F78-A548-1C39BE6264BB}"/>
                </a:ext>
              </a:extLst>
            </p:cNvPr>
            <p:cNvSpPr txBox="1"/>
            <p:nvPr/>
          </p:nvSpPr>
          <p:spPr>
            <a:xfrm>
              <a:off x="2397118" y="639035"/>
              <a:ext cx="50463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&lt;0.05</a:t>
              </a:r>
            </a:p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&lt;0.01</a:t>
              </a:r>
            </a:p>
          </p:txBody>
        </p:sp>
      </p:grp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BA179E75-ABFF-405A-9B75-0F6D86B3324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9938127"/>
              </p:ext>
            </p:extLst>
          </p:nvPr>
        </p:nvGraphicFramePr>
        <p:xfrm>
          <a:off x="662353" y="906729"/>
          <a:ext cx="2603735" cy="15545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407701" imgH="2631646" progId="Prism9.Document">
                  <p:embed/>
                </p:oleObj>
              </mc:Choice>
              <mc:Fallback>
                <p:oleObj name="Prism 9" r:id="rId4" imgW="4407701" imgH="263164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62353" y="906729"/>
                        <a:ext cx="2603735" cy="15545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2C095123-BEB9-4926-B5C9-BF92E2A663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4901108"/>
              </p:ext>
            </p:extLst>
          </p:nvPr>
        </p:nvGraphicFramePr>
        <p:xfrm>
          <a:off x="3817796" y="441845"/>
          <a:ext cx="2365236" cy="24863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721642" imgH="3912353" progId="Prism9.Document">
                  <p:embed/>
                </p:oleObj>
              </mc:Choice>
              <mc:Fallback>
                <p:oleObj name="Prism 9" r:id="rId6" imgW="3721642" imgH="391235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817796" y="441845"/>
                        <a:ext cx="2365236" cy="24863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375863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33D8B13C-6A11-4E9D-A8A9-839762E58E0A}"/>
              </a:ext>
            </a:extLst>
          </p:cNvPr>
          <p:cNvSpPr/>
          <p:nvPr/>
        </p:nvSpPr>
        <p:spPr>
          <a:xfrm>
            <a:off x="25837" y="8081014"/>
            <a:ext cx="680569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900"/>
              </a:lnSpc>
              <a:defRPr/>
            </a:pPr>
            <a:r>
              <a:rPr lang="en-US" sz="9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5. Epigenome-wide association study (EWAS) and genome-wide gene expression analysis for oxygen (O</a:t>
            </a:r>
            <a:r>
              <a:rPr lang="en-US" sz="9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) treatment in 14-day-old </a:t>
            </a:r>
            <a:r>
              <a:rPr lang="en-US" sz="9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mature infants.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A) A Manhattan plot displays O</a:t>
            </a:r>
            <a:r>
              <a:rPr lang="en-US" sz="900" baseline="-2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ssociated </a:t>
            </a:r>
            <a:r>
              <a:rPr lang="en-US" sz="9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n day 14 by comparison of no O</a:t>
            </a:r>
            <a:r>
              <a:rPr lang="en-US" sz="900" baseline="-2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exposed nonBPD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 = 28) and prolonged (</a:t>
            </a:r>
            <a:r>
              <a:rPr lang="en-US" sz="900" u="sng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&gt;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 d) O</a:t>
            </a:r>
            <a:r>
              <a:rPr lang="en-US" sz="900" baseline="-2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exposed nonBPD (n = 20) infants by robust linear regression analysis with adjustment for ten covariates. A total of  41 CpGs (69 annotated genes) were significant following Bonferroni (BF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&lt; 6.08-E08, red line) and 346 CpGs (529 annotated genes) at false discovery rate (FDR) &lt; 0.01 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lue line)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. (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) Similar gene ontologies and pathways between NICU O</a:t>
            </a:r>
            <a:r>
              <a:rPr lang="en-US" sz="900" baseline="-2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dependent epigenome (529 associated genes) and transcriptome (RNA-Seq, 513 genes at FDR &lt; 0.01) determined by Ingenuity Pathway Analysis, </a:t>
            </a:r>
            <a:r>
              <a:rPr lang="en-US" sz="9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ppGene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uite, Reactome Pathway Database, and Gene Set Enrichment Analysis tools. Genes underlined are common in two analyses.</a:t>
            </a:r>
          </a:p>
        </p:txBody>
      </p:sp>
      <p:sp>
        <p:nvSpPr>
          <p:cNvPr id="56" name="Rectangle 7370">
            <a:extLst>
              <a:ext uri="{FF2B5EF4-FFF2-40B4-BE49-F238E27FC236}">
                <a16:creationId xmlns:a16="http://schemas.microsoft.com/office/drawing/2014/main" id="{3568BBE7-BDC2-449B-8DBA-B67E605F3A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-10123" y="352629"/>
            <a:ext cx="304461" cy="17763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1pPr>
            <a:lvl2pPr marL="742950" indent="-28575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2pPr>
            <a:lvl3pPr marL="11430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3pPr>
            <a:lvl4pPr marL="16002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4pPr>
            <a:lvl5pPr marL="20574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5pPr>
            <a:lvl6pPr marL="25146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6pPr>
            <a:lvl7pPr marL="29718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7pPr>
            <a:lvl8pPr marL="34290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8pPr>
            <a:lvl9pPr marL="38862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="0" dirty="0">
                <a:solidFill>
                  <a:prstClr val="black"/>
                </a:solidFill>
                <a:ea typeface="굴림" panose="020B0600000101010101" pitchFamily="34" charset="-127"/>
                <a:cs typeface="Arial" panose="020B0604020202020204" pitchFamily="34" charset="0"/>
              </a:rPr>
              <a:t>A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굴림" panose="020B0600000101010101" pitchFamily="34" charset="-127"/>
                <a:cs typeface="Arial" panose="020B0604020202020204" pitchFamily="34" charset="0"/>
              </a:rPr>
              <a:t>B</a:t>
            </a: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굴림" panose="020B0600000101010101" pitchFamily="34" charset="-127"/>
              <a:cs typeface="Arial" panose="020B0604020202020204" pitchFamily="34" charset="0"/>
            </a:endParaRPr>
          </a:p>
        </p:txBody>
      </p:sp>
      <p:graphicFrame>
        <p:nvGraphicFramePr>
          <p:cNvPr id="39" name="Table 38">
            <a:extLst>
              <a:ext uri="{FF2B5EF4-FFF2-40B4-BE49-F238E27FC236}">
                <a16:creationId xmlns:a16="http://schemas.microsoft.com/office/drawing/2014/main" id="{F7354A89-3439-441E-8C27-9006DD81E3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29759612"/>
              </p:ext>
            </p:extLst>
          </p:nvPr>
        </p:nvGraphicFramePr>
        <p:xfrm>
          <a:off x="218510" y="2094843"/>
          <a:ext cx="6586804" cy="589301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09501">
                  <a:extLst>
                    <a:ext uri="{9D8B030D-6E8A-4147-A177-3AD203B41FA5}">
                      <a16:colId xmlns:a16="http://schemas.microsoft.com/office/drawing/2014/main" val="3430475969"/>
                    </a:ext>
                  </a:extLst>
                </a:gridCol>
                <a:gridCol w="409073">
                  <a:extLst>
                    <a:ext uri="{9D8B030D-6E8A-4147-A177-3AD203B41FA5}">
                      <a16:colId xmlns:a16="http://schemas.microsoft.com/office/drawing/2014/main" val="1750193229"/>
                    </a:ext>
                  </a:extLst>
                </a:gridCol>
                <a:gridCol w="4868230">
                  <a:extLst>
                    <a:ext uri="{9D8B030D-6E8A-4147-A177-3AD203B41FA5}">
                      <a16:colId xmlns:a16="http://schemas.microsoft.com/office/drawing/2014/main" val="2031501748"/>
                    </a:ext>
                  </a:extLst>
                </a:gridCol>
              </a:tblGrid>
              <a:tr h="18304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Gene Ontology/Pathway</a:t>
                      </a:r>
                    </a:p>
                  </a:txBody>
                  <a:tcPr marL="9525" marR="952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Analysis</a:t>
                      </a:r>
                    </a:p>
                  </a:txBody>
                  <a:tcPr marL="9525" marR="952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Associated Genes</a:t>
                      </a:r>
                    </a:p>
                  </a:txBody>
                  <a:tcPr marL="9525" marR="952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939414"/>
                  </a:ext>
                </a:extLst>
              </a:tr>
              <a:tr h="177633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ellular assembly</a:t>
                      </a:r>
                    </a:p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ell-cell adhesion, cytoskeleton organization, cytoplasm organization, migration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EWAS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ACTB,ADAMTS8,ADM,AGAP2,</a:t>
                      </a:r>
                      <a:r>
                        <a:rPr lang="en-US" sz="600" b="0" i="0" u="sng" strike="noStrike" dirty="0">
                          <a:effectLst/>
                          <a:latin typeface="Arial Narrow" panose="020B0606020202030204" pitchFamily="34" charset="0"/>
                        </a:rPr>
                        <a:t>AGRN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,ARRB2,ASB2,AXL,BCAR3,BCL11B,BMP4,CDH23,CDH4,CEP131,CEP290,CEP83,CHRNA7,CNR2,COMT,CPT1C,CUX2,DAB1,DBNL,ELMO1,EPHB1,EXTL3,FGD4,FLII,GLI2,HDAC4,HIP1R,HTR7,ICOS,ID2,KCNC3,KIFC1,KIRREL3,KIT,KLHL17,LRPAP1,MAD2L1,MAP3K13,MAPKAPK2,MOB2,NDUFC1,NGF,NRCAM,PCDHAC1,PDLIM7,PHLDB2,POU3F2,PRKCE,PRMT1,RAC1,RASD2,RGS6,RNF165,ROBO2,ROR1,RPL24,SDK2,SEMA3B,SEMA5A,SEPTIN9,SERPINE1,SLC12A5,SLIT1,SMAD1,SMAD4,SRGAP1,SRGAP2,TBCD,TEMM3,TNN,TNR,TP73,TRAF6,TRAF7,TRIO,TUBB3,TYK2,UST,ZNF423. etc.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3526167"/>
                  </a:ext>
                </a:extLst>
              </a:tr>
              <a:tr h="214842">
                <a:tc v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RNA-Seq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ACAP2,ADAM10,ADD3,</a:t>
                      </a:r>
                      <a:r>
                        <a:rPr lang="en-US" sz="600" b="0" i="0" u="sng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AGRN</a:t>
                      </a: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,ANXA1,ARHGDIA,ARHGEF17,ATG2A,ARSA,BAX,CAMK4,CD47,CDK11B,CERT1,CLSTN1,CNTROB,CSNK1D,CUL3,CUL4B,CYLD,DIAPH1,DOCK11,DVL2,EP300,ERBIN,FAM83H,FASN,FOXM1,GBF1,GCC2,GNG7,HDAC2,HIPK2,HSPB1,HTT,IFT88,IGF1R,INF2,KIF2A,JUP,LAMC1,LAMP2,LIG1,LRP1,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 LRPAP1, </a:t>
                      </a: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MAP4, MARK2,MAST3,MINK1,MRTFA, MT2A,MYADM,MYD88,NECTIN1,NUP62,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PDLIM7,PHACTR4,PIK3CA,</a:t>
                      </a: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PIP5K1C,PLXNB3,PLXND1,PRKACB, PRKCD,PRKCSH, PTPN23, PXN, RHOQ,ROCK1, RPGR,SEMA4A,SEPTIN7,SIDT2,SIRPB1,SKIL,SLC9A1,SMARCA4,SSH1,TGFB1,TMEM106B,TNFSF10,TOP2B, UHMK1,ULK1,ZYX, etc.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71826"/>
                  </a:ext>
                </a:extLst>
              </a:tr>
              <a:tr h="177633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Neuron</a:t>
                      </a:r>
                    </a:p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NGF signaling, morphology, axon guidance signaling, familiar neurological disorder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EWAS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ACTB,ADAMTS8,ADGRD1,ADM,AGAP2,</a:t>
                      </a:r>
                      <a:r>
                        <a:rPr lang="en-US" sz="600" b="0" i="0" u="sng" strike="noStrike" dirty="0">
                          <a:effectLst/>
                          <a:latin typeface="Arial Narrow" panose="020B0606020202030204" pitchFamily="34" charset="0"/>
                        </a:rPr>
                        <a:t>AGRN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,ANKRD2,ANO3,APOA4,ARPP21,ATP2A1,AGAP2,BCL11B,BMP4,CHRNA7,CLSTN3,CPT1C,CUX2,DAB1,DBNL,ELMO1, EPHB1,EXTL3,GABBR1,GABRA5,GABRG3,GLI2,HLA-DQB1,HLA-G,ID2,KIFC1,KIRREL3,LRPAP1,MAP3K13,MYOD1,NGF,NRCAM,PDLIM7,PHOX2B,POU3F2,PRKCE, PRMT1,RAC1,RASD2,RNF165,ROBO2,ROR1,RPL24,SDK2,SEMA3B,SLC12A5,SLIT1,SMAD1,</a:t>
                      </a:r>
                      <a:r>
                        <a:rPr lang="en-US" sz="600" b="0" i="0" u="sng" strike="noStrike" dirty="0">
                          <a:effectLst/>
                          <a:latin typeface="Arial Narrow" panose="020B0606020202030204" pitchFamily="34" charset="0"/>
                        </a:rPr>
                        <a:t>SRGAP2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,SUN1,SYN2,TBCD,TNN,TP73,TRAF6,TRIO,TYK2,UST,ZNF423,etc. 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61855362"/>
                  </a:ext>
                </a:extLst>
              </a:tr>
              <a:tr h="177633">
                <a:tc v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RNA-Seq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sng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AGRN</a:t>
                      </a: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,ARID1A,ATN1,ATP1A1,BCORL1,BICRA,CASP2,CC2D1A,CERT1,CIC,BAX,CREBBP, CUL3,CUL4B,DPF2,EP300,FASN,FBXO11,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GABBR1,GLS,</a:t>
                      </a: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HCFC1, HUWE1, IQSEC1,KIF2A,KMT2B,KMT2D,LINS1,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LRPAP1,</a:t>
                      </a: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MAP3K2,MBOAT7,MED12,MED25,NCOR2,PACS1,PEX11B,PIK3CA,RELA,TGFB1,POLR2A,PTPN23,PRKCD,RELA,RLIM, ROCK1,RPS6KA2,RPS6KA3,SETD1A,SETD1B,SLC12A2,SLC9A1,SMARCA4,SMARCC2</a:t>
                      </a:r>
                      <a:r>
                        <a:rPr lang="en-US" sz="600" b="0" i="0" u="sng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,SRGAP2</a:t>
                      </a: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,SUFU,TAF6,TET3, TMEM94,TRAPPC6B, WASHC4,ZMIZ1,etc. 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1676081"/>
                  </a:ext>
                </a:extLst>
              </a:tr>
              <a:tr h="177633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Developmental growth, abnormal morphology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TGF-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 signaling, ID-1 signaling, vitamin D receptor signaling, estrogen receptor signaling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EWAS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ADA,ADM,</a:t>
                      </a:r>
                      <a:r>
                        <a:rPr lang="en-US" sz="600" b="0" i="0" u="sng" strike="noStrike" dirty="0">
                          <a:effectLst/>
                          <a:latin typeface="Arial Narrow" panose="020B0606020202030204" pitchFamily="34" charset="0"/>
                        </a:rPr>
                        <a:t>AGRN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,ANKRD62,ARRB2,ATP2A1,ATP6V1B1,BCAR3,BCL11B,BMP4,CACNB2,CCND1, CDH4,CDK2AP1,CEP290,CHD23,CHRNA7,CTNNA1,CTNNBIP1,CXXC5, DBNL,DLL1,DUSP10,EPHB1,EXTL3,F11,FSRL1,GAK,GLI2,GMDS,HAND2,HDAC4,HOXB5,HOXB6,HOXC4,HS3ST5,ID2,MAPRE2,MAP3K13,MAP4K1,MMD, MYOD1, NCOR1,NGF,NRCAM,PAX7,PAX9,PCDHA4,PDLIM7,POU3F2,PRDM16,PRKCE,PSMB8,RAC1,RASD2RDH13,RGS4,ROBO2,ROR1,RPL38,SCN5A,SDK2, SEMA3B, SEMA5A,SERPINE1,SLIT1,SMAD1,SMAD4,SMOC1,TBDC,TBX3,TBX6,TEMM3,TMED2,TNR,TP73,TRAF6,TLE1,TMTC3,TSKU,UST,ZNF423, etc. 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4746768"/>
                  </a:ext>
                </a:extLst>
              </a:tr>
              <a:tr h="206755">
                <a:tc v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RNA-Seq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ADAM10,</a:t>
                      </a:r>
                      <a:r>
                        <a:rPr lang="en-US" sz="600" b="0" i="0" u="sng" strike="noStrike" dirty="0">
                          <a:effectLst/>
                          <a:latin typeface="Arial Narrow" panose="020B0606020202030204" pitchFamily="34" charset="0"/>
                        </a:rPr>
                        <a:t>AGRN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,ARID1A,ATP1A1,CAMK4,</a:t>
                      </a: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CREBBP,CUL3,CUL4B,DOT1L,EP300,EPN1,G6PD,HGS, HHEX,HTT,HUWE1,IGF1R,IPMK,KDM2A,LIG1,MAML3,MAP2K3,MAP4, MARK2,MBOAT7,MCL1,MED12,MEF2D,MIR17HG,MKI67,MLF2,MLLT1,MLXIP,MPO,MRTFA,MT-ND1,MT-ND4,MTF1,MYD88, NCOR2,NEAT1, NECTIN1,NFIC,NR6A1, NUP62,PBX2,PEX11B,PHACTR4,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PDLIM7,</a:t>
                      </a: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PHF12,PIK3CA,POLR2A,POU2F2,PPP1R12A,PRKACA,PRKAR1A,PRKCD,PRKCSH,PRPF8, PTBP3,PXN,QKI,RAB8B,RELA, SFRP2,SKIL,SLC12A2,SLC39A10,SLC9A1,SMARCA4,SMARCC2,SP2,TAPT1,TASOR,TBL1X,TGFB1,TMEM106B,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TMTC3</a:t>
                      </a: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,TNFSF10,TOP2B,TRA2B,UBR4,ZNF148,etc. 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7874008"/>
                  </a:ext>
                </a:extLst>
              </a:tr>
              <a:tr h="177633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ell and organismal death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 Apoptosis of blood cells, necrosis, ID-1 signaling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EWAS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ADA,ADAMTSL4,ADM,AGAP2,</a:t>
                      </a:r>
                      <a:r>
                        <a:rPr lang="en-US" sz="600" b="0" i="0" u="sng" strike="noStrike" dirty="0">
                          <a:effectLst/>
                          <a:latin typeface="Arial Narrow" panose="020B0606020202030204" pitchFamily="34" charset="0"/>
                        </a:rPr>
                        <a:t>AGRN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,ARRB2,ASB2,ATP2A1,AXL,BCL11B,BMP4,CABIN1, CARD8,CASZ1,CBFB,CCHCR1,CCN6,CCND1CD151,CDH4,CDK2AP1,CHRNA7, CNR2,COL4A2,CTH,CTNNA1,CTNNBIP1,DCPS,DDAH2,DLL1,DUSP10,ELMO1,EVA1C,FAM72A,</a:t>
                      </a:r>
                      <a:r>
                        <a:rPr lang="en-US" sz="600" b="0" i="0" u="sng" strike="noStrike" dirty="0">
                          <a:effectLst/>
                          <a:latin typeface="Arial Narrow" panose="020B0606020202030204" pitchFamily="34" charset="0"/>
                        </a:rPr>
                        <a:t>FBXO11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,FSTL1,</a:t>
                      </a:r>
                      <a:r>
                        <a:rPr lang="en-US" sz="600" b="0" i="0" u="sng" strike="noStrike" dirty="0">
                          <a:effectLst/>
                          <a:latin typeface="Arial Narrow" panose="020B0606020202030204" pitchFamily="34" charset="0"/>
                        </a:rPr>
                        <a:t>GABBR1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,GABRA5,GLI2,GMDS,GUCA2B,HDAC4,HIP1R, HLA-DQB1,HNRNPH1,HSPB8,HUNK,ICOS,ID2,KCNIP3,KIT,LAG3,LAIR1,</a:t>
                      </a:r>
                      <a:r>
                        <a:rPr lang="en-US" sz="600" b="0" i="0" u="sng" strike="noStrike" dirty="0">
                          <a:effectLst/>
                          <a:latin typeface="Arial Narrow" panose="020B0606020202030204" pitchFamily="34" charset="0"/>
                        </a:rPr>
                        <a:t>LRPAP1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,LTK,MAD2L1,MAP4K1,MAPKAPK2, MC1R,MCM2,MMD, MME MOB2,MYOD1,NCOA5, NGF,NLRP1,OBSCN,PAX7,PAX9,PDLIM7,PHOX2B,PLEKHN1,PMAIP1,POU3F2,PRDM9,PRKCE,PRMT ,PSMB8,RAC1,RAG1,RASD2, RBM5,ROR1,SEMA3B,SEPTIN9, SERPINE1,SMAD1,SMAD4,SNHG14,SORCS2,SUN1,TBX3,THAP1,TIMP4,TP73,TRAF6,TRAF7,TYRO3,XPO7,ZBP1,ZNF423, etc.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0209608"/>
                  </a:ext>
                </a:extLst>
              </a:tr>
              <a:tr h="188127">
                <a:tc v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RNA-Seq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ABCE1,</a:t>
                      </a:r>
                      <a:r>
                        <a:rPr lang="pt-BR" sz="600" b="0" i="0" u="sng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AGRN</a:t>
                      </a:r>
                      <a:r>
                        <a:rPr lang="pt-BR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,ANXA1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,</a:t>
                      </a:r>
                      <a:r>
                        <a:rPr lang="pt-BR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BAX,BCL3,BIRC3,</a:t>
                      </a: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CASP2,CASP9,CREBBP,MCL1,MPL,MPO,MYD88,PRKACA,PRKACB,PRKAR1A,</a:t>
                      </a:r>
                      <a:r>
                        <a:rPr lang="pt-BR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CUL3,DVL2,EP300,</a:t>
                      </a:r>
                      <a:r>
                        <a:rPr lang="en-US" sz="600" b="0" i="0" u="sng" strike="noStrike" dirty="0">
                          <a:effectLst/>
                          <a:latin typeface="Arial Narrow" panose="020B0606020202030204" pitchFamily="34" charset="0"/>
                        </a:rPr>
                        <a:t>FBXO11</a:t>
                      </a:r>
                      <a:r>
                        <a:rPr lang="pt-BR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,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GABBR1,HDAC, HIPK2, </a:t>
                      </a:r>
                      <a:r>
                        <a:rPr lang="pt-BR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IGF1R,LRP1,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LRPAP1</a:t>
                      </a:r>
                      <a:r>
                        <a:rPr lang="pt-BR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,MAP2K3,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MCL1,MPO,MYD88,PDLIM7,</a:t>
                      </a:r>
                      <a:r>
                        <a:rPr lang="pt-BR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PIK3CA,PRKCD,SCP2,SCRIB,SEMA4A,SFRP2,SKIL,SLC25A24,SLC39A10,SLC9A1,SLX4,SMARCA4, SMOX,SPN, SRCAP,SREBF2,TAF6,TET3,TGFB1,TMED10,TMX1,TNFSF10,TOMM70,TOP2B,TRIM13,TSPAN2,UBA3,UCHL5,UCP2,UFM1,ULK1,ZBTB7A,ZFP36,ZYX, etc.</a:t>
                      </a:r>
                      <a:endParaRPr lang="en-US" sz="6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3214677"/>
                  </a:ext>
                </a:extLst>
              </a:tr>
              <a:tr h="182880"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Immune system 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hemopoiesis, lymphoid organ formation, RAR activation, TGF-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b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 signaling, NK cell signaling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EWAS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ADA,ADM,AXL,BCL11B,BMP4,CBFB,CCND1,CLEC4M,CNR2,DLL1,DUSP10,EPHB1,</a:t>
                      </a:r>
                      <a:r>
                        <a:rPr lang="en-US" sz="600" b="0" i="0" u="sng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FBXO11,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HLA-DQB1,HLA-G,ICOS,ID2,KIT,LAG3,LTK,</a:t>
                      </a:r>
                      <a:r>
                        <a:rPr lang="en-US" sz="600" b="0" i="0" u="sng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MPIG6B,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NCOR1,RAC1, RAG1, RASD2,ROR1,SDHA,TRAF6,TYK2,TYRO3, etc. 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2701300"/>
                  </a:ext>
                </a:extLst>
              </a:tr>
              <a:tr h="177633">
                <a:tc v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RNA-Seq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ADAM10,AGPAT5,ANXA1,ARHGDIA,ARID1A,ASGRP4,BAX,BCL3,BTLA,CAMK4,CASP9,CBFA2T3,CD200R1,CD47,CLCF1,CREBBP,CRTC2,CUL3,CXCL16,CYLD,DIAPH1,DOCK11,EP300, FASN,</a:t>
                      </a:r>
                      <a:r>
                        <a:rPr lang="en-US" sz="600" b="0" i="0" u="sng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FBXO11</a:t>
                      </a: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,GLS,GPR183,HHEX,HIPK2,HIVEP3,HSPB1,IGF1R,IPMK,KMT2D,LIG1,LILRB4,MARK2,MBD6,MINK1,MIR17HG,</a:t>
                      </a:r>
                      <a:r>
                        <a:rPr lang="en-US" sz="600" b="0" i="0" u="sng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MPIG6B</a:t>
                      </a: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, MPO,MPL,MYD88,MYO9B,OSCAR,PIK3CA,PLXND1, POU2F2,PRKACB,PRKCD,RASGRP4,RELA,RHOQ,SFRP2,SIRPB1,SLC39A10,SLC9A1,SMARCA4,SMOX, SPN,ST3GAL6,STK17,SYVN1,TET3,TGFB1,ZBTB7A,ZFP36,ZMPSTE24, etc.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4951933"/>
                  </a:ext>
                </a:extLst>
              </a:tr>
              <a:tr h="177633"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Inflammation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viral infection, neutrophil activation and degranulation, antiviral signaling, phagosome maturation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EWAS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ACTB,ADA,ADGRD1,ARRB2,ASB2,ATP6V1B1,CHRNA7,CNR2,ELMO1,F11,FSTL1,GABBR1,GABRA5,GABRG3,GALR1,GLI2,GPR160,GPR39,HLA-G,HTR7,ICOS,KIT,LAG3, MC1R,NEIL2,NGF,PRKCE,PRMT1,PTGDR,RAC1,RAG1,RASD2,ROBO2, SCN5A,SERPINE1,TLN2,TP73,TRAF6,TRIO,TUBB3,TYK2,VPS37B,ZNF214, etc.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15285821"/>
                  </a:ext>
                </a:extLst>
              </a:tr>
              <a:tr h="177633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RNA-Seq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ABCE1,ABTB1,ACAP2,ADAM10,ANXA1,APOBEC3F,ARID1A</a:t>
                      </a: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,ARSA,</a:t>
                      </a: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ATF5,ATP1A1,AZU1,BAX,BCL3,BIRC3,BNIP2,CAND1,CASP2,CD164,CD200R1,DC47,CDC42SE2,CERT1,CLCF1,CLK1,CPSF6,CRAMP1,CREBBP,CRISPLD2,CRTC2,CUL3,CXCL16,CYB5R3,DIAPH1,DIMT1,DLGAP4,DNAJC3,DOK3,EP300,EPN1,FASN,FGL2,FOXJ2,FTH1,G6PD,GBF1,GHDC,H3-3A/H3-3B,HDAC2,HGS,HIPK3,HMGA1,HPGD,HUWE1,IGF1R,JUP,KHSRP,LAMP2,LRPPRC,LRSAM1,MAP2K3,MAP4,MARK2, MCL1,MED12,MINK1, MOSPD2, MPSPD2,MPL,MPO,MT-CO1,MT-CYB,MT-ND2,MT-ND3,MT-ND4,MT-ND4L,MT-ND5,MYD88,NCOA6,NCOR2,NECTIN1,NUP62,OSCAR,PABPC1,PCIF1,PDE4A, PHACTR4,PHF12,PHLPP1,PIGK,PIP5K1C,PLXND1,POU2F2,PPM1B,PRAM1,PRKACA,RELA,RHOQ,ROCK1,RPS6KA3,RRM2B, SAMD9,SCAF1,SETD1A,SETD1B,SIRPB1, SPEN,SPN,SREBF2,TGFB1,TMEM106B,TMX1,TNFSF10,TOMM70,TOP2B,TRAPPC8,TSPAN2,UBR4.UBQLN4,ULK1,VAMP2,VAT,ZFP36, ZNF148,ZSWIM8,ZYX, etc. 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06582472"/>
                  </a:ext>
                </a:extLst>
              </a:tr>
              <a:tr h="177633"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Airway disorders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Asthma, allergy, fibrosis idiopathic signaling, bronchopathy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EWAS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ACTB, ADA,ARRB2,ATP2A1,AXL,BMP4,CCND1,CDK2AP1,CHRNA7,COL4A2,CTNNBIP1,DBNL,F11,FSTL1,GAK,GABRA5,GABRG3,GLI2, HLA-G,HTR7,ICOS,KIT, LAG3, MYOG,NCRO1,NEIL2,NGF,PCDHA13,PCDHA2,PCDHA3,PCDHA4,PCDHA5,PCDHA6,PCDHA7,PCDHA8,PCDHA9,PMAIP1,PRMT1,PRKCE,PTGDR,RAC1,RAG1,RASD2, SCN5A,SERPINE1,SMAD1,SMAD4,TP73,TRAF6,TRIO,TUBB3,TYK2,ZNF214,ZNF423, etc.  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7709076"/>
                  </a:ext>
                </a:extLst>
              </a:tr>
              <a:tr h="136045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RNA-Seq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ADAM10,BAX,CERT1,CREBBP,EP300,MAP2K3,MRTFA,PIK3CA,POLR2A,RELA,ROCK1,RPS6KA2,RPS6KA3,TGFB1, etc.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50792011"/>
                  </a:ext>
                </a:extLst>
              </a:tr>
              <a:tr h="177633"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Eye disorders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retinal disorders,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Leber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 optic atrophy, eye development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EWAS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dirty="0">
                          <a:effectLst/>
                          <a:latin typeface="Arial Narrow" panose="020B0606020202030204" pitchFamily="34" charset="0"/>
                        </a:rPr>
                        <a:t>ACTB,ADM,ARRB2,BCAR3,BCL11B,BMP4,CACNB2,CASZ1,CCND1,CDH4,CEP290,CUX2,DLL1,EPHB1,EXTL3,GLI2,GMDS,ID2,MCM2,MYOD1,NRCAM,OBSCN,RAC1, RBP5,RDH13,ROBO2,RPL24,SDK2,SMAD4,SLC12A5,SLIT1,SMOC1,TBCD,TENM3,TSKU,TBCD, etc.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3343980"/>
                  </a:ext>
                </a:extLst>
              </a:tr>
              <a:tr h="177633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RNA-Seq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MT-ATP6,MT-CO3,MT-CYB,MT-ND1,MT-ND2,MT-ND4,MT-ND4L,MT-ND5,PIK3CA,SUFU, etc.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12996262"/>
                  </a:ext>
                </a:extLst>
              </a:tr>
              <a:tr h="133818"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DNA 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damage, repair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EWAS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CCND1,HDAC4, HS3ST5,RASD2,SMAD4, etc.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5188802"/>
                  </a:ext>
                </a:extLst>
              </a:tr>
              <a:tr h="298508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RNA-Seq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ARID1A,BAX,BCL3,BRD4,CASP2,CASP9,CDT1,CNOTCNOT8,EP300,FOXM1,G6PD,HDAC2,HIPK2,HMGA1,HSPB1,HTT,HUWE1,IGF1R,IPMK,KDM2A,LIG1,LRP1,LRPPRC,MEF2D,MKI67,MPO,MYD88,PIK3CA,PPP4R3BL,,RECQL,RIF1,RRM2B,SLX4, SMARCA4,SMARCC2,SMOX,SRCAO,TGFB1,TNFSF10,TOP2B,UBE2N, UCHL5,USP19, ZBTB1, ZMPSTE24, ZNF385A,etc. 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2498723"/>
                  </a:ext>
                </a:extLst>
              </a:tr>
              <a:tr h="177633"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Stress responses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Senescence, oxidative stress response, xenobiotic metabolism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EWAS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ALDH16A1,APOA4,CACNB2,CACNG4,CCND1,HDAC4,HS3ST5,MAP3K13,MAPKAPK2,NCOR1,PPM1A,PRKCE,RAC1,RASD2,SERPINE1,SMAD1,SMAD4,TRAF6,TXNRD2,TYK2,UST,YPEL3, etc. 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0887234"/>
                  </a:ext>
                </a:extLst>
              </a:tr>
              <a:tr h="177633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RNA-Seq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ts val="6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CAMK4,CREBBP,CUL3,DNAJC10,DNAJC3,DNAJC4,EP300,FTH1,G6PD,H3-3A,HMGA1,KDM6B,MAP2K3,MAP3K2,MINK1,NOCR2,PIK3CA,PRKCD,RELA,RPS6KA3, SMOX,TPP1, etc.</a:t>
                      </a:r>
                    </a:p>
                  </a:txBody>
                  <a:tcPr marL="9525" marR="9525" marT="9525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2150568"/>
                  </a:ext>
                </a:extLst>
              </a:tr>
            </a:tbl>
          </a:graphicData>
        </a:graphic>
      </p:graphicFrame>
      <p:grpSp>
        <p:nvGrpSpPr>
          <p:cNvPr id="175" name="Group 174">
            <a:extLst>
              <a:ext uri="{FF2B5EF4-FFF2-40B4-BE49-F238E27FC236}">
                <a16:creationId xmlns:a16="http://schemas.microsoft.com/office/drawing/2014/main" id="{1DC26E12-3ADB-4C33-8129-A1A440F6AE19}"/>
              </a:ext>
            </a:extLst>
          </p:cNvPr>
          <p:cNvGrpSpPr/>
          <p:nvPr/>
        </p:nvGrpSpPr>
        <p:grpSpPr>
          <a:xfrm>
            <a:off x="534525" y="345083"/>
            <a:ext cx="5753238" cy="1747774"/>
            <a:chOff x="534525" y="281285"/>
            <a:chExt cx="5753238" cy="1747774"/>
          </a:xfrm>
        </p:grpSpPr>
        <p:grpSp>
          <p:nvGrpSpPr>
            <p:cNvPr id="172" name="Group 171">
              <a:extLst>
                <a:ext uri="{FF2B5EF4-FFF2-40B4-BE49-F238E27FC236}">
                  <a16:creationId xmlns:a16="http://schemas.microsoft.com/office/drawing/2014/main" id="{A43CE788-6FBD-45F1-BE5B-510D66A73597}"/>
                </a:ext>
              </a:extLst>
            </p:cNvPr>
            <p:cNvGrpSpPr/>
            <p:nvPr/>
          </p:nvGrpSpPr>
          <p:grpSpPr>
            <a:xfrm>
              <a:off x="534525" y="281285"/>
              <a:ext cx="5753238" cy="1747774"/>
              <a:chOff x="534525" y="281285"/>
              <a:chExt cx="5753238" cy="1747774"/>
            </a:xfrm>
          </p:grpSpPr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AAFC8DE1-4791-4640-AE58-6894358E5D9A}"/>
                  </a:ext>
                </a:extLst>
              </p:cNvPr>
              <p:cNvGrpSpPr/>
              <p:nvPr/>
            </p:nvGrpSpPr>
            <p:grpSpPr>
              <a:xfrm>
                <a:off x="534525" y="281285"/>
                <a:ext cx="5753238" cy="1747774"/>
                <a:chOff x="534525" y="281285"/>
                <a:chExt cx="5753238" cy="1747774"/>
              </a:xfrm>
            </p:grpSpPr>
            <p:grpSp>
              <p:nvGrpSpPr>
                <p:cNvPr id="17" name="Group 16">
                  <a:extLst>
                    <a:ext uri="{FF2B5EF4-FFF2-40B4-BE49-F238E27FC236}">
                      <a16:creationId xmlns:a16="http://schemas.microsoft.com/office/drawing/2014/main" id="{134C3319-2C03-495F-8983-08D90FB1E4CC}"/>
                    </a:ext>
                  </a:extLst>
                </p:cNvPr>
                <p:cNvGrpSpPr/>
                <p:nvPr/>
              </p:nvGrpSpPr>
              <p:grpSpPr>
                <a:xfrm>
                  <a:off x="534525" y="281285"/>
                  <a:ext cx="5753238" cy="1747774"/>
                  <a:chOff x="534525" y="281285"/>
                  <a:chExt cx="5753238" cy="1747774"/>
                </a:xfrm>
              </p:grpSpPr>
              <p:pic>
                <p:nvPicPr>
                  <p:cNvPr id="11" name="Picture 10" descr="A picture containing chart&#10;&#10;Description automatically generated">
                    <a:extLst>
                      <a:ext uri="{FF2B5EF4-FFF2-40B4-BE49-F238E27FC236}">
                        <a16:creationId xmlns:a16="http://schemas.microsoft.com/office/drawing/2014/main" id="{B2C2BF3F-5CA4-4520-8280-E6ED4936A08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2347" b="11879"/>
                  <a:stretch/>
                </p:blipFill>
                <p:spPr>
                  <a:xfrm>
                    <a:off x="661845" y="281285"/>
                    <a:ext cx="5625918" cy="1625770"/>
                  </a:xfrm>
                  <a:prstGeom prst="rect">
                    <a:avLst/>
                  </a:prstGeom>
                </p:spPr>
              </p:pic>
              <p:sp>
                <p:nvSpPr>
                  <p:cNvPr id="115" name="TextBox 114">
                    <a:extLst>
                      <a:ext uri="{FF2B5EF4-FFF2-40B4-BE49-F238E27FC236}">
                        <a16:creationId xmlns:a16="http://schemas.microsoft.com/office/drawing/2014/main" id="{F8E06419-DCCC-422B-AC49-773CAA15A7CB}"/>
                      </a:ext>
                    </a:extLst>
                  </p:cNvPr>
                  <p:cNvSpPr txBox="1"/>
                  <p:nvPr/>
                </p:nvSpPr>
                <p:spPr>
                  <a:xfrm>
                    <a:off x="3070919" y="1798227"/>
                    <a:ext cx="929103" cy="230832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Chromosome</a:t>
                    </a:r>
                  </a:p>
                </p:txBody>
              </p:sp>
              <p:sp>
                <p:nvSpPr>
                  <p:cNvPr id="116" name="TextBox 115">
                    <a:extLst>
                      <a:ext uri="{FF2B5EF4-FFF2-40B4-BE49-F238E27FC236}">
                        <a16:creationId xmlns:a16="http://schemas.microsoft.com/office/drawing/2014/main" id="{4FC402D9-8D9D-4009-914E-7581D7ED9735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09322" y="1049579"/>
                    <a:ext cx="681237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Log</a:t>
                    </a:r>
                    <a:r>
                      <a:rPr lang="en-US" sz="9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en-US" sz="9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endParaRPr lang="en-US" sz="900" i="1" baseline="-25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159" name="Straight Connector 158">
                  <a:extLst>
                    <a:ext uri="{FF2B5EF4-FFF2-40B4-BE49-F238E27FC236}">
                      <a16:creationId xmlns:a16="http://schemas.microsoft.com/office/drawing/2014/main" id="{9F7D7454-9A5D-4679-932B-0625FADAF5F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24160" y="1176991"/>
                  <a:ext cx="5175504" cy="0"/>
                </a:xfrm>
                <a:prstGeom prst="line">
                  <a:avLst/>
                </a:prstGeom>
                <a:ln w="12700">
                  <a:solidFill>
                    <a:srgbClr val="0070C0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26BDA017-6AC3-4FA2-8653-F3A81FCFC1EF}"/>
                  </a:ext>
                </a:extLst>
              </p:cNvPr>
              <p:cNvSpPr txBox="1"/>
              <p:nvPr/>
            </p:nvSpPr>
            <p:spPr>
              <a:xfrm>
                <a:off x="5221333" y="541951"/>
                <a:ext cx="388795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RDH13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4B716C35-68D1-4651-A539-F42A010470DD}"/>
                  </a:ext>
                </a:extLst>
              </p:cNvPr>
              <p:cNvSpPr txBox="1"/>
              <p:nvPr/>
            </p:nvSpPr>
            <p:spPr>
              <a:xfrm>
                <a:off x="1719700" y="618004"/>
                <a:ext cx="490203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ts val="600"/>
                  </a:lnSpc>
                </a:pPr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ARPP21</a:t>
                </a:r>
              </a:p>
              <a:p>
                <a:pPr algn="ctr">
                  <a:lnSpc>
                    <a:spcPts val="600"/>
                  </a:lnSpc>
                </a:pPr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MIR128-2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117" name="Straight Arrow Connector 116">
                <a:extLst>
                  <a:ext uri="{FF2B5EF4-FFF2-40B4-BE49-F238E27FC236}">
                    <a16:creationId xmlns:a16="http://schemas.microsoft.com/office/drawing/2014/main" id="{DD36F7F2-1F28-45D2-A1BE-5DA58931918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83340" y="783734"/>
                <a:ext cx="1" cy="109728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Straight Arrow Connector 118">
                <a:extLst>
                  <a:ext uri="{FF2B5EF4-FFF2-40B4-BE49-F238E27FC236}">
                    <a16:creationId xmlns:a16="http://schemas.microsoft.com/office/drawing/2014/main" id="{64870AEB-9A40-42F3-9978-3A85314F0E0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395973" y="815685"/>
                <a:ext cx="79998" cy="99269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Straight Arrow Connector 120">
                <a:extLst>
                  <a:ext uri="{FF2B5EF4-FFF2-40B4-BE49-F238E27FC236}">
                    <a16:creationId xmlns:a16="http://schemas.microsoft.com/office/drawing/2014/main" id="{B212AD9B-D3E0-4AD4-90FE-FACB8D50963B}"/>
                  </a:ext>
                </a:extLst>
              </p:cNvPr>
              <p:cNvCxnSpPr>
                <a:cxnSpLocks/>
              </p:cNvCxnSpPr>
              <p:nvPr/>
            </p:nvCxnSpPr>
            <p:spPr>
              <a:xfrm rot="20400000" flipH="1">
                <a:off x="2947618" y="841598"/>
                <a:ext cx="146304" cy="34168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8D27E7B0-C254-41AA-A02A-6F9018E5713F}"/>
                  </a:ext>
                </a:extLst>
              </p:cNvPr>
              <p:cNvSpPr txBox="1"/>
              <p:nvPr/>
            </p:nvSpPr>
            <p:spPr>
              <a:xfrm>
                <a:off x="2134437" y="675062"/>
                <a:ext cx="388795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LEKR1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125" name="Straight Arrow Connector 124">
                <a:extLst>
                  <a:ext uri="{FF2B5EF4-FFF2-40B4-BE49-F238E27FC236}">
                    <a16:creationId xmlns:a16="http://schemas.microsoft.com/office/drawing/2014/main" id="{FAA782A9-81E8-4699-ADDC-4FAEB44B9CFA}"/>
                  </a:ext>
                </a:extLst>
              </p:cNvPr>
              <p:cNvCxnSpPr>
                <a:cxnSpLocks/>
              </p:cNvCxnSpPr>
              <p:nvPr/>
            </p:nvCxnSpPr>
            <p:spPr>
              <a:xfrm rot="21000000" flipH="1" flipV="1">
                <a:off x="5872314" y="858075"/>
                <a:ext cx="118872" cy="73152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F161D251-8265-4657-BB45-EC796ED55C19}"/>
                  </a:ext>
                </a:extLst>
              </p:cNvPr>
              <p:cNvSpPr txBox="1"/>
              <p:nvPr/>
            </p:nvSpPr>
            <p:spPr>
              <a:xfrm>
                <a:off x="5241182" y="759516"/>
                <a:ext cx="409609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SMAD4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128" name="Straight Arrow Connector 127">
                <a:extLst>
                  <a:ext uri="{FF2B5EF4-FFF2-40B4-BE49-F238E27FC236}">
                    <a16:creationId xmlns:a16="http://schemas.microsoft.com/office/drawing/2014/main" id="{B526378E-3D1C-4A65-9BDF-325AC5268521}"/>
                  </a:ext>
                </a:extLst>
              </p:cNvPr>
              <p:cNvCxnSpPr>
                <a:cxnSpLocks/>
              </p:cNvCxnSpPr>
              <p:nvPr/>
            </p:nvCxnSpPr>
            <p:spPr>
              <a:xfrm rot="19800000" flipV="1">
                <a:off x="4981370" y="796092"/>
                <a:ext cx="133482" cy="4624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0384E3CD-FA1C-4C95-A366-6AEB3B38EACC}"/>
                  </a:ext>
                </a:extLst>
              </p:cNvPr>
              <p:cNvSpPr txBox="1"/>
              <p:nvPr/>
            </p:nvSpPr>
            <p:spPr>
              <a:xfrm>
                <a:off x="4712407" y="737788"/>
                <a:ext cx="380786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MESD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130" name="Straight Arrow Connector 129">
                <a:extLst>
                  <a:ext uri="{FF2B5EF4-FFF2-40B4-BE49-F238E27FC236}">
                    <a16:creationId xmlns:a16="http://schemas.microsoft.com/office/drawing/2014/main" id="{F41C0FB2-80BA-4112-975A-E7AC539EDB47}"/>
                  </a:ext>
                </a:extLst>
              </p:cNvPr>
              <p:cNvCxnSpPr>
                <a:cxnSpLocks/>
              </p:cNvCxnSpPr>
              <p:nvPr/>
            </p:nvCxnSpPr>
            <p:spPr>
              <a:xfrm rot="1800000" flipH="1">
                <a:off x="3298272" y="809297"/>
                <a:ext cx="137160" cy="54864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Straight Arrow Connector 130">
                <a:extLst>
                  <a:ext uri="{FF2B5EF4-FFF2-40B4-BE49-F238E27FC236}">
                    <a16:creationId xmlns:a16="http://schemas.microsoft.com/office/drawing/2014/main" id="{05653816-91D8-42F3-8515-71DA5550CB38}"/>
                  </a:ext>
                </a:extLst>
              </p:cNvPr>
              <p:cNvCxnSpPr>
                <a:cxnSpLocks/>
              </p:cNvCxnSpPr>
              <p:nvPr/>
            </p:nvCxnSpPr>
            <p:spPr>
              <a:xfrm rot="20400000" flipV="1">
                <a:off x="5028829" y="894121"/>
                <a:ext cx="137160" cy="38633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Straight Arrow Connector 131">
                <a:extLst>
                  <a:ext uri="{FF2B5EF4-FFF2-40B4-BE49-F238E27FC236}">
                    <a16:creationId xmlns:a16="http://schemas.microsoft.com/office/drawing/2014/main" id="{9ABE149A-8659-423D-B08E-592A30AB8435}"/>
                  </a:ext>
                </a:extLst>
              </p:cNvPr>
              <p:cNvCxnSpPr>
                <a:cxnSpLocks/>
              </p:cNvCxnSpPr>
              <p:nvPr/>
            </p:nvCxnSpPr>
            <p:spPr>
              <a:xfrm rot="600000">
                <a:off x="5197712" y="721416"/>
                <a:ext cx="109728" cy="36576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id="{05D7EA8B-29AD-42E8-B4EE-2663CBA6C048}"/>
                  </a:ext>
                </a:extLst>
              </p:cNvPr>
              <p:cNvSpPr txBox="1"/>
              <p:nvPr/>
            </p:nvSpPr>
            <p:spPr>
              <a:xfrm>
                <a:off x="2946165" y="651175"/>
                <a:ext cx="442762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lnSpc>
                    <a:spcPts val="600"/>
                  </a:lnSpc>
                </a:pPr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PSMB8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TAP2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3DA8B788-5ADD-4FF5-93BD-A4A98EDE43B8}"/>
                  </a:ext>
                </a:extLst>
              </p:cNvPr>
              <p:cNvSpPr txBox="1"/>
              <p:nvPr/>
            </p:nvSpPr>
            <p:spPr>
              <a:xfrm>
                <a:off x="4862283" y="531154"/>
                <a:ext cx="406610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ts val="600"/>
                  </a:lnSpc>
                </a:pPr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MC1R</a:t>
                </a:r>
              </a:p>
              <a:p>
                <a:pPr algn="ctr">
                  <a:lnSpc>
                    <a:spcPts val="600"/>
                  </a:lnSpc>
                </a:pPr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TUBB3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135" name="Straight Arrow Connector 134">
                <a:extLst>
                  <a:ext uri="{FF2B5EF4-FFF2-40B4-BE49-F238E27FC236}">
                    <a16:creationId xmlns:a16="http://schemas.microsoft.com/office/drawing/2014/main" id="{F0B230C9-D0B0-4597-9F10-665E9E6A712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821015" y="692903"/>
                <a:ext cx="79998" cy="99269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id="{4CE37F5E-4B77-4992-AD07-F054D3784FD4}"/>
                  </a:ext>
                </a:extLst>
              </p:cNvPr>
              <p:cNvSpPr txBox="1"/>
              <p:nvPr/>
            </p:nvSpPr>
            <p:spPr>
              <a:xfrm>
                <a:off x="5807086" y="597592"/>
                <a:ext cx="406610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ts val="600"/>
                  </a:lnSpc>
                </a:pPr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TPTE</a:t>
                </a:r>
              </a:p>
              <a:p>
                <a:pPr algn="ctr">
                  <a:lnSpc>
                    <a:spcPts val="600"/>
                  </a:lnSpc>
                </a:pPr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BAGE2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id="{7EA07327-7B8E-468B-81F8-D8582FDC5AD6}"/>
                  </a:ext>
                </a:extLst>
              </p:cNvPr>
              <p:cNvSpPr txBox="1"/>
              <p:nvPr/>
            </p:nvSpPr>
            <p:spPr>
              <a:xfrm>
                <a:off x="3368573" y="761842"/>
                <a:ext cx="414891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FKBP9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140" name="Straight Arrow Connector 139">
                <a:extLst>
                  <a:ext uri="{FF2B5EF4-FFF2-40B4-BE49-F238E27FC236}">
                    <a16:creationId xmlns:a16="http://schemas.microsoft.com/office/drawing/2014/main" id="{7DC2BF4F-D5FD-4E10-8917-20702A07D51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521075" y="901330"/>
                <a:ext cx="133482" cy="4624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id="{ACD538D0-6185-4B6B-A9EC-DAC5362FF317}"/>
                  </a:ext>
                </a:extLst>
              </p:cNvPr>
              <p:cNvSpPr txBox="1"/>
              <p:nvPr/>
            </p:nvSpPr>
            <p:spPr>
              <a:xfrm>
                <a:off x="5817725" y="871830"/>
                <a:ext cx="389752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EVA1C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142" name="Straight Arrow Connector 141">
                <a:extLst>
                  <a:ext uri="{FF2B5EF4-FFF2-40B4-BE49-F238E27FC236}">
                    <a16:creationId xmlns:a16="http://schemas.microsoft.com/office/drawing/2014/main" id="{63606BBB-E5ED-4869-93AC-5E34DB5113C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59537" y="769041"/>
                <a:ext cx="109728" cy="36576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3" name="TextBox 142">
                <a:extLst>
                  <a:ext uri="{FF2B5EF4-FFF2-40B4-BE49-F238E27FC236}">
                    <a16:creationId xmlns:a16="http://schemas.microsoft.com/office/drawing/2014/main" id="{BB923907-2F92-4CC1-809C-58DC5C6BEE02}"/>
                  </a:ext>
                </a:extLst>
              </p:cNvPr>
              <p:cNvSpPr txBox="1"/>
              <p:nvPr/>
            </p:nvSpPr>
            <p:spPr>
              <a:xfrm>
                <a:off x="4243837" y="608135"/>
                <a:ext cx="406610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ts val="600"/>
                  </a:lnSpc>
                </a:pPr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TMED2</a:t>
                </a:r>
              </a:p>
              <a:p>
                <a:pPr algn="ctr">
                  <a:lnSpc>
                    <a:spcPts val="600"/>
                  </a:lnSpc>
                </a:pPr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DDX55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145" name="TextBox 144">
                <a:extLst>
                  <a:ext uri="{FF2B5EF4-FFF2-40B4-BE49-F238E27FC236}">
                    <a16:creationId xmlns:a16="http://schemas.microsoft.com/office/drawing/2014/main" id="{8CE18835-F076-42FA-A316-97CAA284F004}"/>
                  </a:ext>
                </a:extLst>
              </p:cNvPr>
              <p:cNvSpPr txBox="1"/>
              <p:nvPr/>
            </p:nvSpPr>
            <p:spPr>
              <a:xfrm>
                <a:off x="4171676" y="824376"/>
                <a:ext cx="476086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ADGRD1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146" name="Straight Arrow Connector 145">
                <a:extLst>
                  <a:ext uri="{FF2B5EF4-FFF2-40B4-BE49-F238E27FC236}">
                    <a16:creationId xmlns:a16="http://schemas.microsoft.com/office/drawing/2014/main" id="{0706962D-DEF3-46CD-9854-C1815E4F6C43}"/>
                  </a:ext>
                </a:extLst>
              </p:cNvPr>
              <p:cNvCxnSpPr>
                <a:cxnSpLocks/>
              </p:cNvCxnSpPr>
              <p:nvPr/>
            </p:nvCxnSpPr>
            <p:spPr>
              <a:xfrm rot="19800000" flipH="1">
                <a:off x="1683390" y="686111"/>
                <a:ext cx="17594" cy="134420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7" name="TextBox 146">
                <a:extLst>
                  <a:ext uri="{FF2B5EF4-FFF2-40B4-BE49-F238E27FC236}">
                    <a16:creationId xmlns:a16="http://schemas.microsoft.com/office/drawing/2014/main" id="{35E377A2-8C4A-446A-A7E2-57F7816C9F4E}"/>
                  </a:ext>
                </a:extLst>
              </p:cNvPr>
              <p:cNvSpPr txBox="1"/>
              <p:nvPr/>
            </p:nvSpPr>
            <p:spPr>
              <a:xfrm>
                <a:off x="1491801" y="555067"/>
                <a:ext cx="405570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GPR39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148" name="TextBox 147">
                <a:extLst>
                  <a:ext uri="{FF2B5EF4-FFF2-40B4-BE49-F238E27FC236}">
                    <a16:creationId xmlns:a16="http://schemas.microsoft.com/office/drawing/2014/main" id="{2FB8ECE8-B446-4BAD-B83A-3D9824D8F2A0}"/>
                  </a:ext>
                </a:extLst>
              </p:cNvPr>
              <p:cNvSpPr txBox="1"/>
              <p:nvPr/>
            </p:nvSpPr>
            <p:spPr>
              <a:xfrm>
                <a:off x="911906" y="669183"/>
                <a:ext cx="402543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OTUD3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00C3D3BE-5E01-41A4-ACF9-E454270FDE4D}"/>
                  </a:ext>
                </a:extLst>
              </p:cNvPr>
              <p:cNvSpPr txBox="1"/>
              <p:nvPr/>
            </p:nvSpPr>
            <p:spPr>
              <a:xfrm>
                <a:off x="2540768" y="665273"/>
                <a:ext cx="380786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SCOC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150" name="Straight Arrow Connector 149">
                <a:extLst>
                  <a:ext uri="{FF2B5EF4-FFF2-40B4-BE49-F238E27FC236}">
                    <a16:creationId xmlns:a16="http://schemas.microsoft.com/office/drawing/2014/main" id="{14818BC8-C4A5-4EFB-A3B6-F97EE8FD19A4}"/>
                  </a:ext>
                </a:extLst>
              </p:cNvPr>
              <p:cNvCxnSpPr>
                <a:cxnSpLocks/>
              </p:cNvCxnSpPr>
              <p:nvPr/>
            </p:nvCxnSpPr>
            <p:spPr>
              <a:xfrm rot="600000" flipH="1">
                <a:off x="2529448" y="777585"/>
                <a:ext cx="79998" cy="99269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Straight Arrow Connector 150">
                <a:extLst>
                  <a:ext uri="{FF2B5EF4-FFF2-40B4-BE49-F238E27FC236}">
                    <a16:creationId xmlns:a16="http://schemas.microsoft.com/office/drawing/2014/main" id="{94A538B8-15B6-473E-B546-A5FB20C4A46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186548" y="806160"/>
                <a:ext cx="79998" cy="99269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Straight Arrow Connector 151">
                <a:extLst>
                  <a:ext uri="{FF2B5EF4-FFF2-40B4-BE49-F238E27FC236}">
                    <a16:creationId xmlns:a16="http://schemas.microsoft.com/office/drawing/2014/main" id="{88BCD0DF-0DBF-47C4-B72A-DAC8D792A8BD}"/>
                  </a:ext>
                </a:extLst>
              </p:cNvPr>
              <p:cNvCxnSpPr>
                <a:cxnSpLocks/>
              </p:cNvCxnSpPr>
              <p:nvPr/>
            </p:nvCxnSpPr>
            <p:spPr>
              <a:xfrm rot="19800000" flipH="1">
                <a:off x="1931040" y="790886"/>
                <a:ext cx="17594" cy="134420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2711D746-284F-4BB3-92C2-5CD26D542A14}"/>
                  </a:ext>
                </a:extLst>
              </p:cNvPr>
              <p:cNvSpPr txBox="1"/>
              <p:nvPr/>
            </p:nvSpPr>
            <p:spPr>
              <a:xfrm>
                <a:off x="1204383" y="629176"/>
                <a:ext cx="511587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ts val="600"/>
                  </a:lnSpc>
                </a:pPr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MYOG</a:t>
                </a:r>
              </a:p>
              <a:p>
                <a:pPr algn="ctr">
                  <a:lnSpc>
                    <a:spcPts val="600"/>
                  </a:lnSpc>
                </a:pPr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MYOPARR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154" name="Straight Arrow Connector 153">
                <a:extLst>
                  <a:ext uri="{FF2B5EF4-FFF2-40B4-BE49-F238E27FC236}">
                    <a16:creationId xmlns:a16="http://schemas.microsoft.com/office/drawing/2014/main" id="{562E0149-9DBB-44BA-BF0E-ED75100B528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22310" y="803461"/>
                <a:ext cx="1" cy="109728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5" name="TextBox 154">
                <a:extLst>
                  <a:ext uri="{FF2B5EF4-FFF2-40B4-BE49-F238E27FC236}">
                    <a16:creationId xmlns:a16="http://schemas.microsoft.com/office/drawing/2014/main" id="{201B893D-BD44-454A-9A58-F5E21DB06D57}"/>
                  </a:ext>
                </a:extLst>
              </p:cNvPr>
              <p:cNvSpPr txBox="1"/>
              <p:nvPr/>
            </p:nvSpPr>
            <p:spPr>
              <a:xfrm>
                <a:off x="3731800" y="660646"/>
                <a:ext cx="451573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OR13C9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156" name="TextBox 155">
                <a:extLst>
                  <a:ext uri="{FF2B5EF4-FFF2-40B4-BE49-F238E27FC236}">
                    <a16:creationId xmlns:a16="http://schemas.microsoft.com/office/drawing/2014/main" id="{0A7F18B2-6790-40A2-A93B-FD7FEA01D1C3}"/>
                  </a:ext>
                </a:extLst>
              </p:cNvPr>
              <p:cNvSpPr txBox="1"/>
              <p:nvPr/>
            </p:nvSpPr>
            <p:spPr>
              <a:xfrm>
                <a:off x="4697155" y="836729"/>
                <a:ext cx="423433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PRSS22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157" name="Straight Arrow Connector 156">
                <a:extLst>
                  <a:ext uri="{FF2B5EF4-FFF2-40B4-BE49-F238E27FC236}">
                    <a16:creationId xmlns:a16="http://schemas.microsoft.com/office/drawing/2014/main" id="{CB9CD47C-FE46-4529-91DD-8096FC630A41}"/>
                  </a:ext>
                </a:extLst>
              </p:cNvPr>
              <p:cNvCxnSpPr>
                <a:cxnSpLocks/>
              </p:cNvCxnSpPr>
              <p:nvPr/>
            </p:nvCxnSpPr>
            <p:spPr>
              <a:xfrm rot="19800000" flipV="1">
                <a:off x="5438570" y="767517"/>
                <a:ext cx="133482" cy="4624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Straight Arrow Connector 157">
                <a:extLst>
                  <a:ext uri="{FF2B5EF4-FFF2-40B4-BE49-F238E27FC236}">
                    <a16:creationId xmlns:a16="http://schemas.microsoft.com/office/drawing/2014/main" id="{D4066BA4-0A14-4B87-807A-3B96798D0B3F}"/>
                  </a:ext>
                </a:extLst>
              </p:cNvPr>
              <p:cNvCxnSpPr>
                <a:cxnSpLocks/>
              </p:cNvCxnSpPr>
              <p:nvPr/>
            </p:nvCxnSpPr>
            <p:spPr>
              <a:xfrm rot="600000" flipV="1">
                <a:off x="5541230" y="653005"/>
                <a:ext cx="133482" cy="4624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1" name="TextBox 160">
                <a:extLst>
                  <a:ext uri="{FF2B5EF4-FFF2-40B4-BE49-F238E27FC236}">
                    <a16:creationId xmlns:a16="http://schemas.microsoft.com/office/drawing/2014/main" id="{ABB7DE6D-7D29-4CFC-9607-2E05AEBCCB65}"/>
                  </a:ext>
                </a:extLst>
              </p:cNvPr>
              <p:cNvSpPr txBox="1"/>
              <p:nvPr/>
            </p:nvSpPr>
            <p:spPr>
              <a:xfrm>
                <a:off x="2281753" y="854471"/>
                <a:ext cx="380786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MME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162" name="Straight Arrow Connector 161">
                <a:extLst>
                  <a:ext uri="{FF2B5EF4-FFF2-40B4-BE49-F238E27FC236}">
                    <a16:creationId xmlns:a16="http://schemas.microsoft.com/office/drawing/2014/main" id="{CE093774-1A8A-40B8-8B65-606397F436CA}"/>
                  </a:ext>
                </a:extLst>
              </p:cNvPr>
              <p:cNvCxnSpPr>
                <a:cxnSpLocks/>
              </p:cNvCxnSpPr>
              <p:nvPr/>
            </p:nvCxnSpPr>
            <p:spPr>
              <a:xfrm rot="21000000" flipH="1">
                <a:off x="2190718" y="971804"/>
                <a:ext cx="157166" cy="0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Straight Arrow Connector 163">
                <a:extLst>
                  <a:ext uri="{FF2B5EF4-FFF2-40B4-BE49-F238E27FC236}">
                    <a16:creationId xmlns:a16="http://schemas.microsoft.com/office/drawing/2014/main" id="{9199593F-64D0-4AD1-B60F-9579E9427573}"/>
                  </a:ext>
                </a:extLst>
              </p:cNvPr>
              <p:cNvCxnSpPr>
                <a:cxnSpLocks/>
              </p:cNvCxnSpPr>
              <p:nvPr/>
            </p:nvCxnSpPr>
            <p:spPr>
              <a:xfrm rot="21000000" flipH="1">
                <a:off x="2992337" y="952674"/>
                <a:ext cx="157166" cy="0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6" name="TextBox 165">
                <a:extLst>
                  <a:ext uri="{FF2B5EF4-FFF2-40B4-BE49-F238E27FC236}">
                    <a16:creationId xmlns:a16="http://schemas.microsoft.com/office/drawing/2014/main" id="{0A9A5FAF-2819-4BDB-B077-2080E3C98097}"/>
                  </a:ext>
                </a:extLst>
              </p:cNvPr>
              <p:cNvSpPr txBox="1"/>
              <p:nvPr/>
            </p:nvSpPr>
            <p:spPr>
              <a:xfrm>
                <a:off x="3004268" y="800784"/>
                <a:ext cx="414891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HLA-G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167" name="TextBox 166">
                <a:extLst>
                  <a:ext uri="{FF2B5EF4-FFF2-40B4-BE49-F238E27FC236}">
                    <a16:creationId xmlns:a16="http://schemas.microsoft.com/office/drawing/2014/main" id="{B516D99B-D9AB-4C77-8502-F25F997539ED}"/>
                  </a:ext>
                </a:extLst>
              </p:cNvPr>
              <p:cNvSpPr txBox="1"/>
              <p:nvPr/>
            </p:nvSpPr>
            <p:spPr>
              <a:xfrm>
                <a:off x="1511343" y="806065"/>
                <a:ext cx="405570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ts val="600"/>
                  </a:lnSpc>
                </a:pPr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TIMP4</a:t>
                </a:r>
              </a:p>
              <a:p>
                <a:pPr algn="ctr">
                  <a:lnSpc>
                    <a:spcPts val="600"/>
                  </a:lnSpc>
                </a:pPr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SYN2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168" name="Straight Arrow Connector 167">
                <a:extLst>
                  <a:ext uri="{FF2B5EF4-FFF2-40B4-BE49-F238E27FC236}">
                    <a16:creationId xmlns:a16="http://schemas.microsoft.com/office/drawing/2014/main" id="{911C5694-CCF3-47CF-AC8C-6712EF68F5BB}"/>
                  </a:ext>
                </a:extLst>
              </p:cNvPr>
              <p:cNvCxnSpPr>
                <a:cxnSpLocks/>
              </p:cNvCxnSpPr>
              <p:nvPr/>
            </p:nvCxnSpPr>
            <p:spPr>
              <a:xfrm rot="600000">
                <a:off x="1816337" y="921441"/>
                <a:ext cx="109728" cy="36576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0" name="TextBox 169">
                <a:extLst>
                  <a:ext uri="{FF2B5EF4-FFF2-40B4-BE49-F238E27FC236}">
                    <a16:creationId xmlns:a16="http://schemas.microsoft.com/office/drawing/2014/main" id="{4FA0273C-B6BE-416C-9749-64BC8C3C85ED}"/>
                  </a:ext>
                </a:extLst>
              </p:cNvPr>
              <p:cNvSpPr txBox="1"/>
              <p:nvPr/>
            </p:nvSpPr>
            <p:spPr>
              <a:xfrm>
                <a:off x="5497663" y="718976"/>
                <a:ext cx="360236" cy="18466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600" b="1" i="1" dirty="0">
                    <a:solidFill>
                      <a:srgbClr val="00206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ZBP1</a:t>
                </a:r>
                <a:endParaRPr lang="en-US" sz="600" b="1" dirty="0">
                  <a:solidFill>
                    <a:srgbClr val="002060"/>
                  </a:solidFill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171" name="Straight Arrow Connector 170">
                <a:extLst>
                  <a:ext uri="{FF2B5EF4-FFF2-40B4-BE49-F238E27FC236}">
                    <a16:creationId xmlns:a16="http://schemas.microsoft.com/office/drawing/2014/main" id="{2766F276-E402-4B71-994C-2660844504DC}"/>
                  </a:ext>
                </a:extLst>
              </p:cNvPr>
              <p:cNvCxnSpPr>
                <a:cxnSpLocks/>
              </p:cNvCxnSpPr>
              <p:nvPr/>
            </p:nvCxnSpPr>
            <p:spPr>
              <a:xfrm rot="600000">
                <a:off x="5681044" y="856398"/>
                <a:ext cx="109728" cy="36576"/>
              </a:xfrm>
              <a:prstGeom prst="straightConnector1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0AB4738E-D6B5-4893-9592-DABD37531202}"/>
                </a:ext>
              </a:extLst>
            </p:cNvPr>
            <p:cNvSpPr txBox="1"/>
            <p:nvPr/>
          </p:nvSpPr>
          <p:spPr>
            <a:xfrm>
              <a:off x="2163618" y="393687"/>
              <a:ext cx="27391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o-O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vs High-O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(≥ 14 days) on Day 14</a:t>
              </a:r>
            </a:p>
          </p:txBody>
        </p:sp>
      </p:grpSp>
      <p:sp>
        <p:nvSpPr>
          <p:cNvPr id="173" name="TextBox 172">
            <a:extLst>
              <a:ext uri="{FF2B5EF4-FFF2-40B4-BE49-F238E27FC236}">
                <a16:creationId xmlns:a16="http://schemas.microsoft.com/office/drawing/2014/main" id="{E97895DA-0321-47CD-AEB8-DE6F32655964}"/>
              </a:ext>
            </a:extLst>
          </p:cNvPr>
          <p:cNvSpPr txBox="1"/>
          <p:nvPr/>
        </p:nvSpPr>
        <p:spPr>
          <a:xfrm>
            <a:off x="6092127" y="14965"/>
            <a:ext cx="834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. S5</a:t>
            </a:r>
            <a:endParaRPr lang="en-US" sz="14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60892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Chart, scatter chart&#10;&#10;Description automatically generated">
            <a:extLst>
              <a:ext uri="{FF2B5EF4-FFF2-40B4-BE49-F238E27FC236}">
                <a16:creationId xmlns:a16="http://schemas.microsoft.com/office/drawing/2014/main" id="{BF938D64-5C9B-9F35-5540-357104CADDA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5319"/>
          <a:stretch/>
        </p:blipFill>
        <p:spPr>
          <a:xfrm>
            <a:off x="3482868" y="201604"/>
            <a:ext cx="3306312" cy="349206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F7ABFBA-4C3A-3092-956E-8663FE3A1213}"/>
              </a:ext>
            </a:extLst>
          </p:cNvPr>
          <p:cNvSpPr txBox="1"/>
          <p:nvPr/>
        </p:nvSpPr>
        <p:spPr>
          <a:xfrm>
            <a:off x="6116172" y="-8468"/>
            <a:ext cx="7682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. S6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776C6CC-093A-91EC-EEC0-3CEC3DD3F0D7}"/>
              </a:ext>
            </a:extLst>
          </p:cNvPr>
          <p:cNvSpPr/>
          <p:nvPr/>
        </p:nvSpPr>
        <p:spPr>
          <a:xfrm>
            <a:off x="94238" y="6940702"/>
            <a:ext cx="666952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6. Principal component analysis (PCA) plots of unadjusted peripheral blood DNA methylation data from bronchopulmonary dysplasia (BPD) and nonBPD neonates used in the epigenome-wide association study (EWAS).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eparation of samples along PCA1 axis of postnatal day 14 (A), day 28 (B) and combined (C) appears related to cell-type distribution differences associated with gestational age. Red circles or triangles = BPD. Black circles or triangles = nonBPD. In (C), c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rcles indicate day 14 and triangles indicate day 28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WAS analysis was adjusted for gestational age, birthweight, sex, and seven cell-type percentages.</a:t>
            </a:r>
          </a:p>
        </p:txBody>
      </p:sp>
      <p:sp>
        <p:nvSpPr>
          <p:cNvPr id="6" name="Rectangle 7370">
            <a:extLst>
              <a:ext uri="{FF2B5EF4-FFF2-40B4-BE49-F238E27FC236}">
                <a16:creationId xmlns:a16="http://schemas.microsoft.com/office/drawing/2014/main" id="{EF58396D-9897-025B-9463-EBFC384A48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04233" y="3784915"/>
            <a:ext cx="306222" cy="7238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1pPr>
            <a:lvl2pPr marL="742950" indent="-28575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2pPr>
            <a:lvl3pPr marL="11430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3pPr>
            <a:lvl4pPr marL="16002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4pPr>
            <a:lvl5pPr marL="20574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5pPr>
            <a:lvl6pPr marL="25146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6pPr>
            <a:lvl7pPr marL="29718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7pPr>
            <a:lvl8pPr marL="34290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8pPr>
            <a:lvl9pPr marL="38862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="0" dirty="0">
                <a:solidFill>
                  <a:prstClr val="black"/>
                </a:solidFill>
                <a:ea typeface="굴림" panose="020B0600000101010101" pitchFamily="34" charset="-127"/>
                <a:cs typeface="Arial" panose="020B0604020202020204" pitchFamily="34" charset="0"/>
              </a:rPr>
              <a:t>C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</p:txBody>
      </p:sp>
      <p:pic>
        <p:nvPicPr>
          <p:cNvPr id="8" name="Picture 7" descr="Chart, scatter chart&#10;&#10;Description automatically generated">
            <a:extLst>
              <a:ext uri="{FF2B5EF4-FFF2-40B4-BE49-F238E27FC236}">
                <a16:creationId xmlns:a16="http://schemas.microsoft.com/office/drawing/2014/main" id="{2FF2A6DD-5252-FA4F-CEAD-C6C8152BE63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3522"/>
          <a:stretch/>
        </p:blipFill>
        <p:spPr>
          <a:xfrm>
            <a:off x="162067" y="219168"/>
            <a:ext cx="3335165" cy="3456938"/>
          </a:xfrm>
          <a:prstGeom prst="rect">
            <a:avLst/>
          </a:prstGeom>
        </p:spPr>
      </p:pic>
      <p:sp>
        <p:nvSpPr>
          <p:cNvPr id="7" name="Rectangle 7370">
            <a:extLst>
              <a:ext uri="{FF2B5EF4-FFF2-40B4-BE49-F238E27FC236}">
                <a16:creationId xmlns:a16="http://schemas.microsoft.com/office/drawing/2014/main" id="{7788DD44-EEC8-F2EF-0B62-771ABB7C69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09245" y="322215"/>
            <a:ext cx="263893" cy="2890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1pPr>
            <a:lvl2pPr marL="742950" indent="-28575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2pPr>
            <a:lvl3pPr marL="11430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3pPr>
            <a:lvl4pPr marL="16002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4pPr>
            <a:lvl5pPr marL="20574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5pPr>
            <a:lvl6pPr marL="25146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6pPr>
            <a:lvl7pPr marL="29718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7pPr>
            <a:lvl8pPr marL="34290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8pPr>
            <a:lvl9pPr marL="38862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="0" dirty="0">
                <a:solidFill>
                  <a:prstClr val="black"/>
                </a:solidFill>
                <a:ea typeface="굴림" panose="020B0600000101010101" pitchFamily="34" charset="-127"/>
                <a:cs typeface="Arial" panose="020B0604020202020204" pitchFamily="34" charset="0"/>
              </a:rPr>
              <a:t>B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</p:txBody>
      </p:sp>
      <p:sp>
        <p:nvSpPr>
          <p:cNvPr id="9" name="Rectangle 7370">
            <a:extLst>
              <a:ext uri="{FF2B5EF4-FFF2-40B4-BE49-F238E27FC236}">
                <a16:creationId xmlns:a16="http://schemas.microsoft.com/office/drawing/2014/main" id="{92478544-A5B5-9E13-22A2-DAED77FC3D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6498" y="290256"/>
            <a:ext cx="263893" cy="2890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1pPr>
            <a:lvl2pPr marL="742950" indent="-28575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2pPr>
            <a:lvl3pPr marL="11430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3pPr>
            <a:lvl4pPr marL="16002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4pPr>
            <a:lvl5pPr marL="20574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5pPr>
            <a:lvl6pPr marL="25146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6pPr>
            <a:lvl7pPr marL="29718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7pPr>
            <a:lvl8pPr marL="34290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8pPr>
            <a:lvl9pPr marL="38862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="0" dirty="0">
                <a:solidFill>
                  <a:prstClr val="black"/>
                </a:solidFill>
                <a:ea typeface="굴림" panose="020B0600000101010101" pitchFamily="34" charset="-127"/>
                <a:cs typeface="Arial" panose="020B0604020202020204" pitchFamily="34" charset="0"/>
              </a:rPr>
              <a:t>A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F4AFE0C-1346-7CEB-9E3E-3EC94DF07AEB}"/>
              </a:ext>
            </a:extLst>
          </p:cNvPr>
          <p:cNvSpPr txBox="1"/>
          <p:nvPr/>
        </p:nvSpPr>
        <p:spPr>
          <a:xfrm>
            <a:off x="681025" y="68992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y 14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48AF7C8-9CF2-C32B-71F9-DE8F34215ED2}"/>
              </a:ext>
            </a:extLst>
          </p:cNvPr>
          <p:cNvSpPr txBox="1"/>
          <p:nvPr/>
        </p:nvSpPr>
        <p:spPr>
          <a:xfrm>
            <a:off x="3941191" y="73189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y 28</a:t>
            </a:r>
          </a:p>
        </p:txBody>
      </p:sp>
      <p:pic>
        <p:nvPicPr>
          <p:cNvPr id="14" name="Picture 13" descr="Chart, scatter chart&#10;&#10;Description automatically generated">
            <a:extLst>
              <a:ext uri="{FF2B5EF4-FFF2-40B4-BE49-F238E27FC236}">
                <a16:creationId xmlns:a16="http://schemas.microsoft.com/office/drawing/2014/main" id="{68A5132D-D196-E36D-F774-314DA21996C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1919"/>
          <a:stretch/>
        </p:blipFill>
        <p:spPr>
          <a:xfrm>
            <a:off x="1725174" y="3562554"/>
            <a:ext cx="3650232" cy="32151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404147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F7ABFBA-4C3A-3092-956E-8663FE3A1213}"/>
              </a:ext>
            </a:extLst>
          </p:cNvPr>
          <p:cNvSpPr txBox="1"/>
          <p:nvPr/>
        </p:nvSpPr>
        <p:spPr>
          <a:xfrm>
            <a:off x="6116172" y="-8468"/>
            <a:ext cx="7682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. S7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776C6CC-093A-91EC-EEC0-3CEC3DD3F0D7}"/>
              </a:ext>
            </a:extLst>
          </p:cNvPr>
          <p:cNvSpPr/>
          <p:nvPr/>
        </p:nvSpPr>
        <p:spPr>
          <a:xfrm>
            <a:off x="94238" y="7556538"/>
            <a:ext cx="666952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. S7. Principal component analysis (PCA) of blood cell gene expression dataset from preterm neonates with bronchopulmonary dysplasia (BPD) and without (nonBPD) used in the RNA-sequencing (RNA-Seq) analyses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ots depict relationships between samples based on PCA1, PCA2 and PCA3 (A, C, E) or PCA2, PCA3 and PCA4 (B, D, F). Points are colored by disease group (A, B cord blood); (C, D postnatal day 14); (E, F, postnatal day 28</a:t>
            </a:r>
            <a:r>
              <a:rPr lang="en-US" sz="10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An outlier in cord blood samples (in dotted boxes) was excluded from the analysis. Blue circles = BPD. Red circles = nonBPD received ≥ 1 day of oxygen supplementation in the newborn intensive care unit.</a:t>
            </a:r>
          </a:p>
        </p:txBody>
      </p:sp>
      <p:sp>
        <p:nvSpPr>
          <p:cNvPr id="6" name="Rectangle 7370">
            <a:extLst>
              <a:ext uri="{FF2B5EF4-FFF2-40B4-BE49-F238E27FC236}">
                <a16:creationId xmlns:a16="http://schemas.microsoft.com/office/drawing/2014/main" id="{EF58396D-9897-025B-9463-EBFC384A48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4783" y="400076"/>
            <a:ext cx="262220" cy="4550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1pPr>
            <a:lvl2pPr marL="742950" indent="-28575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2pPr>
            <a:lvl3pPr marL="11430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3pPr>
            <a:lvl4pPr marL="16002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4pPr>
            <a:lvl5pPr marL="20574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5pPr>
            <a:lvl6pPr marL="25146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6pPr>
            <a:lvl7pPr marL="29718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7pPr>
            <a:lvl8pPr marL="34290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8pPr>
            <a:lvl9pPr marL="38862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="0" dirty="0">
                <a:solidFill>
                  <a:prstClr val="black"/>
                </a:solidFill>
                <a:ea typeface="굴림" panose="020B0600000101010101" pitchFamily="34" charset="-127"/>
                <a:cs typeface="Arial" panose="020B0604020202020204" pitchFamily="34" charset="0"/>
              </a:rPr>
              <a:t>A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="0" dirty="0">
                <a:solidFill>
                  <a:prstClr val="black"/>
                </a:solidFill>
                <a:ea typeface="굴림" panose="020B0600000101010101" pitchFamily="34" charset="-127"/>
                <a:cs typeface="Arial" panose="020B0604020202020204" pitchFamily="34" charset="0"/>
              </a:rPr>
              <a:t>C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="0" dirty="0">
                <a:solidFill>
                  <a:prstClr val="black"/>
                </a:solidFill>
                <a:ea typeface="굴림" panose="020B0600000101010101" pitchFamily="34" charset="-127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17" name="Picture 16" descr="Chart, scatter chart&#10;&#10;Description automatically generated">
            <a:extLst>
              <a:ext uri="{FF2B5EF4-FFF2-40B4-BE49-F238E27FC236}">
                <a16:creationId xmlns:a16="http://schemas.microsoft.com/office/drawing/2014/main" id="{8637A3BD-70C0-5D4B-5A18-F879845B473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contrast="4000"/>
                    </a14:imgEffect>
                  </a14:imgLayer>
                </a14:imgProps>
              </a:ext>
            </a:extLst>
          </a:blip>
          <a:srcRect l="20540" t="5045" r="27317"/>
          <a:stretch/>
        </p:blipFill>
        <p:spPr>
          <a:xfrm>
            <a:off x="3363576" y="434641"/>
            <a:ext cx="2231062" cy="1816509"/>
          </a:xfrm>
          <a:prstGeom prst="rect">
            <a:avLst/>
          </a:prstGeom>
        </p:spPr>
      </p:pic>
      <p:pic>
        <p:nvPicPr>
          <p:cNvPr id="21" name="Picture 20" descr="Chart, scatter chart&#10;&#10;Description automatically generated">
            <a:extLst>
              <a:ext uri="{FF2B5EF4-FFF2-40B4-BE49-F238E27FC236}">
                <a16:creationId xmlns:a16="http://schemas.microsoft.com/office/drawing/2014/main" id="{5F16E7D7-D54E-EEB9-F850-F579AA916F8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  <a14:imgEffect>
                      <a14:brightnessContrast contrast="5000"/>
                    </a14:imgEffect>
                  </a14:imgLayer>
                </a14:imgProps>
              </a:ext>
            </a:extLst>
          </a:blip>
          <a:srcRect l="27966" t="2445" r="23463"/>
          <a:stretch/>
        </p:blipFill>
        <p:spPr>
          <a:xfrm>
            <a:off x="3651853" y="2531578"/>
            <a:ext cx="2193476" cy="1969733"/>
          </a:xfrm>
          <a:prstGeom prst="rect">
            <a:avLst/>
          </a:prstGeom>
        </p:spPr>
      </p:pic>
      <p:pic>
        <p:nvPicPr>
          <p:cNvPr id="23" name="Picture 22" descr="Chart, scatter chart&#10;&#10;Description automatically generated">
            <a:extLst>
              <a:ext uri="{FF2B5EF4-FFF2-40B4-BE49-F238E27FC236}">
                <a16:creationId xmlns:a16="http://schemas.microsoft.com/office/drawing/2014/main" id="{6B8DD0E0-1A8D-9FEA-20EB-9F921045714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25000"/>
                    </a14:imgEffect>
                    <a14:imgEffect>
                      <a14:brightnessContrast contrast="5000"/>
                    </a14:imgEffect>
                  </a14:imgLayer>
                </a14:imgProps>
              </a:ext>
            </a:extLst>
          </a:blip>
          <a:srcRect l="21973" t="8492" r="23358"/>
          <a:stretch/>
        </p:blipFill>
        <p:spPr>
          <a:xfrm>
            <a:off x="780812" y="2772342"/>
            <a:ext cx="2310281" cy="1728969"/>
          </a:xfrm>
          <a:prstGeom prst="rect">
            <a:avLst/>
          </a:prstGeom>
        </p:spPr>
      </p:pic>
      <p:pic>
        <p:nvPicPr>
          <p:cNvPr id="25" name="Picture 24" descr="Chart, scatter chart&#10;&#10;Description automatically generated">
            <a:extLst>
              <a:ext uri="{FF2B5EF4-FFF2-40B4-BE49-F238E27FC236}">
                <a16:creationId xmlns:a16="http://schemas.microsoft.com/office/drawing/2014/main" id="{90DC009D-C96D-1FAA-606C-6E74D9A19AE5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25000"/>
                    </a14:imgEffect>
                    <a14:imgEffect>
                      <a14:brightnessContrast contrast="5000"/>
                    </a14:imgEffect>
                  </a14:imgLayer>
                </a14:imgProps>
              </a:ext>
            </a:extLst>
          </a:blip>
          <a:srcRect l="25238" t="7916" r="23951"/>
          <a:stretch/>
        </p:blipFill>
        <p:spPr>
          <a:xfrm>
            <a:off x="689498" y="4849980"/>
            <a:ext cx="2492908" cy="1873447"/>
          </a:xfrm>
          <a:prstGeom prst="rect">
            <a:avLst/>
          </a:prstGeom>
        </p:spPr>
      </p:pic>
      <p:pic>
        <p:nvPicPr>
          <p:cNvPr id="27" name="Picture 26" descr="Chart, scatter chart&#10;&#10;Description automatically generated">
            <a:extLst>
              <a:ext uri="{FF2B5EF4-FFF2-40B4-BE49-F238E27FC236}">
                <a16:creationId xmlns:a16="http://schemas.microsoft.com/office/drawing/2014/main" id="{F33AC345-92CE-5735-418D-E0F55F2F1A2B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25000"/>
                    </a14:imgEffect>
                    <a14:imgEffect>
                      <a14:brightnessContrast contrast="5000"/>
                    </a14:imgEffect>
                  </a14:imgLayer>
                </a14:imgProps>
              </a:ext>
            </a:extLst>
          </a:blip>
          <a:srcRect l="19586" t="6284" r="25631"/>
          <a:stretch/>
        </p:blipFill>
        <p:spPr>
          <a:xfrm>
            <a:off x="3387829" y="4903844"/>
            <a:ext cx="2575379" cy="1969733"/>
          </a:xfrm>
          <a:prstGeom prst="rect">
            <a:avLst/>
          </a:prstGeom>
        </p:spPr>
      </p:pic>
      <p:pic>
        <p:nvPicPr>
          <p:cNvPr id="28" name="Picture 27" descr="Chart, scatter chart&#10;&#10;Description automatically generated">
            <a:extLst>
              <a:ext uri="{FF2B5EF4-FFF2-40B4-BE49-F238E27FC236}">
                <a16:creationId xmlns:a16="http://schemas.microsoft.com/office/drawing/2014/main" id="{16053256-E637-1920-D107-EAC0A8F75EE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contrast="4000"/>
                    </a14:imgEffect>
                  </a14:imgLayer>
                </a14:imgProps>
              </a:ext>
            </a:extLst>
          </a:blip>
          <a:srcRect l="95463" t="3869" r="-619" b="87379"/>
          <a:stretch/>
        </p:blipFill>
        <p:spPr>
          <a:xfrm>
            <a:off x="5511654" y="1078645"/>
            <a:ext cx="837112" cy="635373"/>
          </a:xfrm>
          <a:prstGeom prst="rect">
            <a:avLst/>
          </a:prstGeom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id="{4413627A-D120-8E25-45DC-EC7881780BE7}"/>
              </a:ext>
            </a:extLst>
          </p:cNvPr>
          <p:cNvSpPr/>
          <p:nvPr/>
        </p:nvSpPr>
        <p:spPr>
          <a:xfrm>
            <a:off x="3773154" y="1989438"/>
            <a:ext cx="210064" cy="193471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1" name="Picture 30" descr="Chart&#10;&#10;Description automatically generated">
            <a:extLst>
              <a:ext uri="{FF2B5EF4-FFF2-40B4-BE49-F238E27FC236}">
                <a16:creationId xmlns:a16="http://schemas.microsoft.com/office/drawing/2014/main" id="{9638D501-F7EF-4486-41AE-F00D46821E44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25000"/>
                    </a14:imgEffect>
                    <a14:imgEffect>
                      <a14:brightnessContrast contrast="5000"/>
                    </a14:imgEffect>
                  </a14:imgLayer>
                </a14:imgProps>
              </a:ext>
            </a:extLst>
          </a:blip>
          <a:srcRect l="24091" t="6097" r="27801"/>
          <a:stretch/>
        </p:blipFill>
        <p:spPr>
          <a:xfrm>
            <a:off x="777003" y="434641"/>
            <a:ext cx="2279172" cy="1989032"/>
          </a:xfrm>
          <a:prstGeom prst="rect">
            <a:avLst/>
          </a:prstGeom>
        </p:spPr>
      </p:pic>
      <p:sp>
        <p:nvSpPr>
          <p:cNvPr id="32" name="Rectangle 31">
            <a:extLst>
              <a:ext uri="{FF2B5EF4-FFF2-40B4-BE49-F238E27FC236}">
                <a16:creationId xmlns:a16="http://schemas.microsoft.com/office/drawing/2014/main" id="{60B513FE-FA2C-E490-AEC3-E35926154F09}"/>
              </a:ext>
            </a:extLst>
          </p:cNvPr>
          <p:cNvSpPr/>
          <p:nvPr/>
        </p:nvSpPr>
        <p:spPr>
          <a:xfrm>
            <a:off x="1050609" y="1342895"/>
            <a:ext cx="210064" cy="193471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Rectangle 7370">
            <a:extLst>
              <a:ext uri="{FF2B5EF4-FFF2-40B4-BE49-F238E27FC236}">
                <a16:creationId xmlns:a16="http://schemas.microsoft.com/office/drawing/2014/main" id="{FCBA1D7B-ECDE-3E6B-E59A-119C4B4DDD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64583" y="353173"/>
            <a:ext cx="262220" cy="4550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1pPr>
            <a:lvl2pPr marL="742950" indent="-28575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2pPr>
            <a:lvl3pPr marL="11430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3pPr>
            <a:lvl4pPr marL="16002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4pPr>
            <a:lvl5pPr marL="2057400" indent="-228600" eaLnBrk="0" hangingPunct="0"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5pPr>
            <a:lvl6pPr marL="25146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6pPr>
            <a:lvl7pPr marL="29718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7pPr>
            <a:lvl8pPr marL="34290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8pPr>
            <a:lvl9pPr marL="3886200" indent="-228600" algn="just"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tx1"/>
                </a:solidFill>
                <a:latin typeface="Arial" panose="020B0604020202020204" pitchFamily="34" charset="0"/>
                <a:cs typeface="Times New Roman" panose="02020603050405020304" pitchFamily="18" charset="0"/>
              </a:defRPr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="0" dirty="0">
                <a:solidFill>
                  <a:prstClr val="black"/>
                </a:solidFill>
                <a:ea typeface="굴림" panose="020B0600000101010101" pitchFamily="34" charset="-127"/>
                <a:cs typeface="Arial" panose="020B0604020202020204" pitchFamily="34" charset="0"/>
              </a:rPr>
              <a:t>B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="0" dirty="0">
                <a:solidFill>
                  <a:prstClr val="black"/>
                </a:solidFill>
                <a:ea typeface="굴림" panose="020B0600000101010101" pitchFamily="34" charset="-127"/>
                <a:cs typeface="Arial" panose="020B0604020202020204" pitchFamily="34" charset="0"/>
              </a:rPr>
              <a:t>D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b="0" dirty="0">
              <a:solidFill>
                <a:prstClr val="black"/>
              </a:solidFill>
              <a:ea typeface="굴림" panose="020B0600000101010101" pitchFamily="34" charset="-127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="0" dirty="0">
                <a:solidFill>
                  <a:prstClr val="black"/>
                </a:solidFill>
                <a:ea typeface="굴림" panose="020B0600000101010101" pitchFamily="34" charset="-127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21550B7-E7D9-E838-7759-09F244B1F57F}"/>
              </a:ext>
            </a:extLst>
          </p:cNvPr>
          <p:cNvSpPr txBox="1"/>
          <p:nvPr/>
        </p:nvSpPr>
        <p:spPr>
          <a:xfrm>
            <a:off x="1313254" y="1839952"/>
            <a:ext cx="8226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rd Bloo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9EBBD0C-6151-E5EE-0630-9B23C75FA49D}"/>
              </a:ext>
            </a:extLst>
          </p:cNvPr>
          <p:cNvSpPr txBox="1"/>
          <p:nvPr/>
        </p:nvSpPr>
        <p:spPr>
          <a:xfrm>
            <a:off x="1164770" y="3953383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y 1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5BA5E94-18E9-D187-BC3D-912A0A9A25E4}"/>
              </a:ext>
            </a:extLst>
          </p:cNvPr>
          <p:cNvSpPr txBox="1"/>
          <p:nvPr/>
        </p:nvSpPr>
        <p:spPr>
          <a:xfrm>
            <a:off x="1724584" y="6150732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y 28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533E729-6F4A-F5EB-F85B-1825ACDE2BEA}"/>
              </a:ext>
            </a:extLst>
          </p:cNvPr>
          <p:cNvSpPr txBox="1"/>
          <p:nvPr/>
        </p:nvSpPr>
        <p:spPr>
          <a:xfrm>
            <a:off x="4194234" y="1764846"/>
            <a:ext cx="8226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rd Bloo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B873F21-125B-4FF3-4BDF-4E50A10F4577}"/>
              </a:ext>
            </a:extLst>
          </p:cNvPr>
          <p:cNvSpPr txBox="1"/>
          <p:nvPr/>
        </p:nvSpPr>
        <p:spPr>
          <a:xfrm>
            <a:off x="4005980" y="396985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y 1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E0AEAEC-80A8-2F08-ACBF-EE50E0730C34}"/>
              </a:ext>
            </a:extLst>
          </p:cNvPr>
          <p:cNvSpPr txBox="1"/>
          <p:nvPr/>
        </p:nvSpPr>
        <p:spPr>
          <a:xfrm>
            <a:off x="5134519" y="6230374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y 28</a:t>
            </a:r>
          </a:p>
        </p:txBody>
      </p:sp>
    </p:spTree>
    <p:extLst>
      <p:ext uri="{BB962C8B-B14F-4D97-AF65-F5344CB8AC3E}">
        <p14:creationId xmlns:p14="http://schemas.microsoft.com/office/powerpoint/2010/main" val="22918514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895</TotalTime>
  <Words>3627</Words>
  <Application>Microsoft Office PowerPoint</Application>
  <PresentationFormat>On-screen Show (4:3)</PresentationFormat>
  <Paragraphs>259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Arial</vt:lpstr>
      <vt:lpstr>Arial Narrow</vt:lpstr>
      <vt:lpstr>Calibri</vt:lpstr>
      <vt:lpstr>Calibri Light</vt:lpstr>
      <vt:lpstr>Symbol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, Hye-Youn (NIH/NIEHS) [E]</dc:creator>
  <cp:lastModifiedBy>Bell, Douglas (NIH/NIEHS) [V]</cp:lastModifiedBy>
  <cp:revision>1308</cp:revision>
  <cp:lastPrinted>2023-01-23T16:59:30Z</cp:lastPrinted>
  <dcterms:created xsi:type="dcterms:W3CDTF">2021-06-23T16:08:56Z</dcterms:created>
  <dcterms:modified xsi:type="dcterms:W3CDTF">2023-07-03T17:16:16Z</dcterms:modified>
</cp:coreProperties>
</file>